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19799300" cy="162004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Μεσαίο στυλ 2 - Έμφαση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41" autoAdjust="0"/>
    <p:restoredTop sz="94660"/>
  </p:normalViewPr>
  <p:slideViewPr>
    <p:cSldViewPr snapToGrid="0">
      <p:cViewPr>
        <p:scale>
          <a:sx n="50" d="100"/>
          <a:sy n="50" d="100"/>
        </p:scale>
        <p:origin x="730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OANNIS CHATZIEFFRAIMIDIS" userId="b961d053ce115571" providerId="LiveId" clId="{EEE8EA51-0644-4221-A89F-49C2277D6B76}"/>
    <pc:docChg chg="undo redo custSel addSld delSld modSld modMainMaster">
      <pc:chgData name="IOANNIS CHATZIEFFRAIMIDIS" userId="b961d053ce115571" providerId="LiveId" clId="{EEE8EA51-0644-4221-A89F-49C2277D6B76}" dt="2025-11-10T09:45:52.268" v="5639" actId="20577"/>
      <pc:docMkLst>
        <pc:docMk/>
      </pc:docMkLst>
      <pc:sldChg chg="addSp delSp modSp add mod">
        <pc:chgData name="IOANNIS CHATZIEFFRAIMIDIS" userId="b961d053ce115571" providerId="LiveId" clId="{EEE8EA51-0644-4221-A89F-49C2277D6B76}" dt="2025-11-10T09:45:52.268" v="5639" actId="20577"/>
        <pc:sldMkLst>
          <pc:docMk/>
          <pc:sldMk cId="1742971463" sldId="256"/>
        </pc:sldMkLst>
        <pc:spChg chg="add mod">
          <ac:chgData name="IOANNIS CHATZIEFFRAIMIDIS" userId="b961d053ce115571" providerId="LiveId" clId="{EEE8EA51-0644-4221-A89F-49C2277D6B76}" dt="2025-11-09T18:24:19.229" v="5399" actId="14100"/>
          <ac:spMkLst>
            <pc:docMk/>
            <pc:sldMk cId="1742971463" sldId="256"/>
            <ac:spMk id="2" creationId="{8AB1C4F4-A943-9183-FC95-7AE0573C4904}"/>
          </ac:spMkLst>
        </pc:spChg>
        <pc:spChg chg="add mod">
          <ac:chgData name="IOANNIS CHATZIEFFRAIMIDIS" userId="b961d053ce115571" providerId="LiveId" clId="{EEE8EA51-0644-4221-A89F-49C2277D6B76}" dt="2025-11-09T18:26:25.863" v="5633" actId="1076"/>
          <ac:spMkLst>
            <pc:docMk/>
            <pc:sldMk cId="1742971463" sldId="256"/>
            <ac:spMk id="3" creationId="{3747F537-BD9F-94F1-FA11-82ABA92C73DC}"/>
          </ac:spMkLst>
        </pc:spChg>
        <pc:spChg chg="add 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11" creationId="{0BE57A75-D152-854A-2138-6872173EEEAB}"/>
          </ac:spMkLst>
        </pc:spChg>
        <pc:spChg chg="add mod">
          <ac:chgData name="IOANNIS CHATZIEFFRAIMIDIS" userId="b961d053ce115571" providerId="LiveId" clId="{EEE8EA51-0644-4221-A89F-49C2277D6B76}" dt="2025-11-07T10:18:55.650" v="4104" actId="14100"/>
          <ac:spMkLst>
            <pc:docMk/>
            <pc:sldMk cId="1742971463" sldId="256"/>
            <ac:spMk id="12" creationId="{DFBD221D-4EDA-3672-0866-315227EA4C4D}"/>
          </ac:spMkLst>
        </pc:spChg>
        <pc:spChg chg="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82" creationId="{24929E74-0661-C574-EDCD-6A644CDEBB1D}"/>
          </ac:spMkLst>
        </pc:spChg>
        <pc:spChg chg="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84" creationId="{0B4128AB-6F4A-7BF6-40E8-078E37511D39}"/>
          </ac:spMkLst>
        </pc:spChg>
        <pc:spChg chg="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86" creationId="{9F905FCD-DB4B-E09E-D3CB-A4462F3F4EE0}"/>
          </ac:spMkLst>
        </pc:spChg>
        <pc:spChg chg="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92" creationId="{DF8FFC27-3C27-6FAB-13CA-344F319EF89F}"/>
          </ac:spMkLst>
        </pc:spChg>
        <pc:spChg chg="mod">
          <ac:chgData name="IOANNIS CHATZIEFFRAIMIDIS" userId="b961d053ce115571" providerId="LiveId" clId="{EEE8EA51-0644-4221-A89F-49C2277D6B76}" dt="2025-11-10T09:45:47.279" v="5637" actId="20577"/>
          <ac:spMkLst>
            <pc:docMk/>
            <pc:sldMk cId="1742971463" sldId="256"/>
            <ac:spMk id="97" creationId="{81A3591E-67CA-B3CC-00B6-2ABEB931EED7}"/>
          </ac:spMkLst>
        </pc:spChg>
        <pc:spChg chg="mod">
          <ac:chgData name="IOANNIS CHATZIEFFRAIMIDIS" userId="b961d053ce115571" providerId="LiveId" clId="{EEE8EA51-0644-4221-A89F-49C2277D6B76}" dt="2025-11-10T09:45:52.268" v="5639" actId="20577"/>
          <ac:spMkLst>
            <pc:docMk/>
            <pc:sldMk cId="1742971463" sldId="256"/>
            <ac:spMk id="98" creationId="{C1E18749-065F-084D-4EBC-F930E2190CA1}"/>
          </ac:spMkLst>
        </pc:spChg>
        <pc:spChg chg="mod">
          <ac:chgData name="IOANNIS CHATZIEFFRAIMIDIS" userId="b961d053ce115571" providerId="LiveId" clId="{EEE8EA51-0644-4221-A89F-49C2277D6B76}" dt="2025-11-07T11:13:34.554" v="5300" actId="1076"/>
          <ac:spMkLst>
            <pc:docMk/>
            <pc:sldMk cId="1742971463" sldId="256"/>
            <ac:spMk id="101" creationId="{275E5A65-F95E-BAF8-A49A-B039D6777EC9}"/>
          </ac:spMkLst>
        </pc:spChg>
        <pc:spChg chg="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102" creationId="{FC83DCC4-49D6-E59E-3A35-F9E913BC9B7C}"/>
          </ac:spMkLst>
        </pc:spChg>
        <pc:spChg chg="mod">
          <ac:chgData name="IOANNIS CHATZIEFFRAIMIDIS" userId="b961d053ce115571" providerId="LiveId" clId="{EEE8EA51-0644-4221-A89F-49C2277D6B76}" dt="2025-11-07T10:12:18.408" v="3635"/>
          <ac:spMkLst>
            <pc:docMk/>
            <pc:sldMk cId="1742971463" sldId="256"/>
            <ac:spMk id="121" creationId="{C22D3DAB-B010-09B1-E1D3-815EFDFF04D2}"/>
          </ac:spMkLst>
        </pc:spChg>
        <pc:spChg chg="mod ord">
          <ac:chgData name="IOANNIS CHATZIEFFRAIMIDIS" userId="b961d053ce115571" providerId="LiveId" clId="{EEE8EA51-0644-4221-A89F-49C2277D6B76}" dt="2025-11-07T10:18:07.764" v="3950" actId="167"/>
          <ac:spMkLst>
            <pc:docMk/>
            <pc:sldMk cId="1742971463" sldId="256"/>
            <ac:spMk id="122" creationId="{8737283A-1191-DE6F-598B-AEE0E8A6634E}"/>
          </ac:spMkLst>
        </pc:spChg>
        <pc:spChg chg="add 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124" creationId="{680EA563-0F65-6F60-C462-361B873955F0}"/>
          </ac:spMkLst>
        </pc:spChg>
        <pc:spChg chg="mod">
          <ac:chgData name="IOANNIS CHATZIEFFRAIMIDIS" userId="b961d053ce115571" providerId="LiveId" clId="{EEE8EA51-0644-4221-A89F-49C2277D6B76}" dt="2025-11-07T10:16:13.089" v="3848"/>
          <ac:spMkLst>
            <pc:docMk/>
            <pc:sldMk cId="1742971463" sldId="256"/>
            <ac:spMk id="127" creationId="{B3BDB3AE-AFD8-81E7-A356-25A7A64618AD}"/>
          </ac:spMkLst>
        </pc:spChg>
        <pc:spChg chg="mod">
          <ac:chgData name="IOANNIS CHATZIEFFRAIMIDIS" userId="b961d053ce115571" providerId="LiveId" clId="{EEE8EA51-0644-4221-A89F-49C2277D6B76}" dt="2025-11-07T11:15:27.969" v="5328" actId="1036"/>
          <ac:spMkLst>
            <pc:docMk/>
            <pc:sldMk cId="1742971463" sldId="256"/>
            <ac:spMk id="128" creationId="{CA39D0C9-0FFA-28D7-FD01-8CBC6105EF1B}"/>
          </ac:spMkLst>
        </pc:spChg>
        <pc:spChg chg="add mod">
          <ac:chgData name="IOANNIS CHATZIEFFRAIMIDIS" userId="b961d053ce115571" providerId="LiveId" clId="{EEE8EA51-0644-4221-A89F-49C2277D6B76}" dt="2025-11-09T18:25:49.547" v="5629" actId="1036"/>
          <ac:spMkLst>
            <pc:docMk/>
            <pc:sldMk cId="1742971463" sldId="256"/>
            <ac:spMk id="129" creationId="{5442FAE5-78B7-8243-D1CC-02C060C703B0}"/>
          </ac:spMkLst>
        </pc:spChg>
        <pc:spChg chg="mod topLvl">
          <ac:chgData name="IOANNIS CHATZIEFFRAIMIDIS" userId="b961d053ce115571" providerId="LiveId" clId="{EEE8EA51-0644-4221-A89F-49C2277D6B76}" dt="2025-11-07T10:41:51.145" v="4337" actId="164"/>
          <ac:spMkLst>
            <pc:docMk/>
            <pc:sldMk cId="1742971463" sldId="256"/>
            <ac:spMk id="150" creationId="{1CD18C57-34D3-8D9C-9613-FF387A244BD1}"/>
          </ac:spMkLst>
        </pc:spChg>
        <pc:spChg chg="mod">
          <ac:chgData name="IOANNIS CHATZIEFFRAIMIDIS" userId="b961d053ce115571" providerId="LiveId" clId="{EEE8EA51-0644-4221-A89F-49C2277D6B76}" dt="2025-11-07T10:41:45.615" v="4336" actId="165"/>
          <ac:spMkLst>
            <pc:docMk/>
            <pc:sldMk cId="1742971463" sldId="256"/>
            <ac:spMk id="153" creationId="{C00F81F2-3606-D022-AACC-CED77BA7A9B9}"/>
          </ac:spMkLst>
        </pc:spChg>
        <pc:spChg chg="mod">
          <ac:chgData name="IOANNIS CHATZIEFFRAIMIDIS" userId="b961d053ce115571" providerId="LiveId" clId="{EEE8EA51-0644-4221-A89F-49C2277D6B76}" dt="2025-11-07T10:48:15.201" v="4390"/>
          <ac:spMkLst>
            <pc:docMk/>
            <pc:sldMk cId="1742971463" sldId="256"/>
            <ac:spMk id="158" creationId="{E0F9FDD5-E922-36EF-3341-38EBBD3C064D}"/>
          </ac:spMkLst>
        </pc:spChg>
        <pc:spChg chg="mod">
          <ac:chgData name="IOANNIS CHATZIEFFRAIMIDIS" userId="b961d053ce115571" providerId="LiveId" clId="{EEE8EA51-0644-4221-A89F-49C2277D6B76}" dt="2025-11-07T10:48:15.201" v="4390"/>
          <ac:spMkLst>
            <pc:docMk/>
            <pc:sldMk cId="1742971463" sldId="256"/>
            <ac:spMk id="160" creationId="{597A2B0E-7523-3265-41E2-4E9CBCEAFD9B}"/>
          </ac:spMkLst>
        </pc:spChg>
        <pc:spChg chg="mod">
          <ac:chgData name="IOANNIS CHATZIEFFRAIMIDIS" userId="b961d053ce115571" providerId="LiveId" clId="{EEE8EA51-0644-4221-A89F-49C2277D6B76}" dt="2025-11-07T10:48:50.760" v="4428" actId="1038"/>
          <ac:spMkLst>
            <pc:docMk/>
            <pc:sldMk cId="1742971463" sldId="256"/>
            <ac:spMk id="161" creationId="{55A70CF4-B39F-0B28-8D6F-DFE1085E786A}"/>
          </ac:spMkLst>
        </pc:spChg>
        <pc:spChg chg="add mod">
          <ac:chgData name="IOANNIS CHATZIEFFRAIMIDIS" userId="b961d053ce115571" providerId="LiveId" clId="{EEE8EA51-0644-4221-A89F-49C2277D6B76}" dt="2025-11-07T11:11:46.614" v="5177" actId="164"/>
          <ac:spMkLst>
            <pc:docMk/>
            <pc:sldMk cId="1742971463" sldId="256"/>
            <ac:spMk id="162" creationId="{EE63931F-0651-94DF-DD80-2EDD7BACF2DF}"/>
          </ac:spMkLst>
        </pc:spChg>
        <pc:spChg chg="mod">
          <ac:chgData name="IOANNIS CHATZIEFFRAIMIDIS" userId="b961d053ce115571" providerId="LiveId" clId="{EEE8EA51-0644-4221-A89F-49C2277D6B76}" dt="2025-11-07T11:05:25.365" v="4949" actId="14100"/>
          <ac:spMkLst>
            <pc:docMk/>
            <pc:sldMk cId="1742971463" sldId="256"/>
            <ac:spMk id="184" creationId="{56BD01F8-00C8-ADAA-0807-C5D707E21C7E}"/>
          </ac:spMkLst>
        </pc:spChg>
        <pc:spChg chg="mod">
          <ac:chgData name="IOANNIS CHATZIEFFRAIMIDIS" userId="b961d053ce115571" providerId="LiveId" clId="{EEE8EA51-0644-4221-A89F-49C2277D6B76}" dt="2025-11-07T11:04:07.985" v="4942" actId="14100"/>
          <ac:spMkLst>
            <pc:docMk/>
            <pc:sldMk cId="1742971463" sldId="256"/>
            <ac:spMk id="185" creationId="{D5BDCBB7-C19B-9EF2-EF05-85C9196BE155}"/>
          </ac:spMkLst>
        </pc:spChg>
        <pc:spChg chg="mod">
          <ac:chgData name="IOANNIS CHATZIEFFRAIMIDIS" userId="b961d053ce115571" providerId="LiveId" clId="{EEE8EA51-0644-4221-A89F-49C2277D6B76}" dt="2025-11-07T11:12:37.213" v="5288" actId="1035"/>
          <ac:spMkLst>
            <pc:docMk/>
            <pc:sldMk cId="1742971463" sldId="256"/>
            <ac:spMk id="186" creationId="{CEA399F7-D7B0-F3B8-1E65-E938A5919781}"/>
          </ac:spMkLst>
        </pc:spChg>
        <pc:spChg chg="mod">
          <ac:chgData name="IOANNIS CHATZIEFFRAIMIDIS" userId="b961d053ce115571" providerId="LiveId" clId="{EEE8EA51-0644-4221-A89F-49C2277D6B76}" dt="2025-11-07T11:09:59.287" v="5080"/>
          <ac:spMkLst>
            <pc:docMk/>
            <pc:sldMk cId="1742971463" sldId="256"/>
            <ac:spMk id="194" creationId="{53765332-2530-EAD5-AF50-F697DE1D8D83}"/>
          </ac:spMkLst>
        </pc:spChg>
        <pc:spChg chg="add mod">
          <ac:chgData name="IOANNIS CHATZIEFFRAIMIDIS" userId="b961d053ce115571" providerId="LiveId" clId="{EEE8EA51-0644-4221-A89F-49C2277D6B76}" dt="2025-11-07T11:11:26.604" v="5143" actId="164"/>
          <ac:spMkLst>
            <pc:docMk/>
            <pc:sldMk cId="1742971463" sldId="256"/>
            <ac:spMk id="195" creationId="{36E51BDF-5232-6D5B-8B3B-C0ED1E819CE0}"/>
          </ac:spMkLst>
        </pc:spChg>
        <pc:grpChg chg="add mod">
          <ac:chgData name="IOANNIS CHATZIEFFRAIMIDIS" userId="b961d053ce115571" providerId="LiveId" clId="{EEE8EA51-0644-4221-A89F-49C2277D6B76}" dt="2025-11-07T10:18:21.938" v="3957" actId="164"/>
          <ac:grpSpMkLst>
            <pc:docMk/>
            <pc:sldMk cId="1742971463" sldId="256"/>
            <ac:grpSpMk id="120" creationId="{915BCD9F-E109-9D1E-2D4A-B0A5D2AA0CAA}"/>
          </ac:grpSpMkLst>
        </pc:grpChg>
        <pc:grpChg chg="add mod">
          <ac:chgData name="IOANNIS CHATZIEFFRAIMIDIS" userId="b961d053ce115571" providerId="LiveId" clId="{EEE8EA51-0644-4221-A89F-49C2277D6B76}" dt="2025-11-07T11:16:15.652" v="5389" actId="1035"/>
          <ac:grpSpMkLst>
            <pc:docMk/>
            <pc:sldMk cId="1742971463" sldId="256"/>
            <ac:grpSpMk id="126" creationId="{BB7B6F34-4955-5A54-323C-EE9AB9EA70B8}"/>
          </ac:grpSpMkLst>
        </pc:grpChg>
        <pc:grpChg chg="add mod">
          <ac:chgData name="IOANNIS CHATZIEFFRAIMIDIS" userId="b961d053ce115571" providerId="LiveId" clId="{EEE8EA51-0644-4221-A89F-49C2277D6B76}" dt="2025-11-07T10:18:39.390" v="4101" actId="1037"/>
          <ac:grpSpMkLst>
            <pc:docMk/>
            <pc:sldMk cId="1742971463" sldId="256"/>
            <ac:grpSpMk id="133" creationId="{A17F5638-01F9-6E1F-0D46-AC779938475C}"/>
          </ac:grpSpMkLst>
        </pc:grpChg>
        <pc:grpChg chg="mod topLvl">
          <ac:chgData name="IOANNIS CHATZIEFFRAIMIDIS" userId="b961d053ce115571" providerId="LiveId" clId="{EEE8EA51-0644-4221-A89F-49C2277D6B76}" dt="2025-11-07T10:41:51.145" v="4337" actId="164"/>
          <ac:grpSpMkLst>
            <pc:docMk/>
            <pc:sldMk cId="1742971463" sldId="256"/>
            <ac:grpSpMk id="149" creationId="{0BA8303E-DA1E-ADA9-77CB-0A3C9440FE14}"/>
          </ac:grpSpMkLst>
        </pc:grpChg>
        <pc:grpChg chg="add mod">
          <ac:chgData name="IOANNIS CHATZIEFFRAIMIDIS" userId="b961d053ce115571" providerId="LiveId" clId="{EEE8EA51-0644-4221-A89F-49C2277D6B76}" dt="2025-11-07T11:11:46.614" v="5177" actId="164"/>
          <ac:grpSpMkLst>
            <pc:docMk/>
            <pc:sldMk cId="1742971463" sldId="256"/>
            <ac:grpSpMk id="154" creationId="{733355B8-7892-4200-6621-C37E5564C4B0}"/>
          </ac:grpSpMkLst>
        </pc:grpChg>
        <pc:grpChg chg="add mod">
          <ac:chgData name="IOANNIS CHATZIEFFRAIMIDIS" userId="b961d053ce115571" providerId="LiveId" clId="{EEE8EA51-0644-4221-A89F-49C2277D6B76}" dt="2025-11-07T11:11:06.759" v="5100" actId="164"/>
          <ac:grpSpMkLst>
            <pc:docMk/>
            <pc:sldMk cId="1742971463" sldId="256"/>
            <ac:grpSpMk id="156" creationId="{885174C8-5E68-B5B8-2C18-B3E1B07A1454}"/>
          </ac:grpSpMkLst>
        </pc:grpChg>
        <pc:grpChg chg="mod">
          <ac:chgData name="IOANNIS CHATZIEFFRAIMIDIS" userId="b961d053ce115571" providerId="LiveId" clId="{EEE8EA51-0644-4221-A89F-49C2277D6B76}" dt="2025-11-07T10:48:15.201" v="4390"/>
          <ac:grpSpMkLst>
            <pc:docMk/>
            <pc:sldMk cId="1742971463" sldId="256"/>
            <ac:grpSpMk id="157" creationId="{81FC9E3C-B2FD-A95A-1E13-6CA84BBDF14F}"/>
          </ac:grpSpMkLst>
        </pc:grpChg>
        <pc:grpChg chg="add mod">
          <ac:chgData name="IOANNIS CHATZIEFFRAIMIDIS" userId="b961d053ce115571" providerId="LiveId" clId="{EEE8EA51-0644-4221-A89F-49C2277D6B76}" dt="2025-11-07T11:12:26.517" v="5285" actId="14100"/>
          <ac:grpSpMkLst>
            <pc:docMk/>
            <pc:sldMk cId="1742971463" sldId="256"/>
            <ac:grpSpMk id="180" creationId="{6EA3AC93-A664-9341-0768-215332655473}"/>
          </ac:grpSpMkLst>
        </pc:grpChg>
        <pc:grpChg chg="mod">
          <ac:chgData name="IOANNIS CHATZIEFFRAIMIDIS" userId="b961d053ce115571" providerId="LiveId" clId="{EEE8EA51-0644-4221-A89F-49C2277D6B76}" dt="2025-11-07T11:03:51.995" v="4939"/>
          <ac:grpSpMkLst>
            <pc:docMk/>
            <pc:sldMk cId="1742971463" sldId="256"/>
            <ac:grpSpMk id="182" creationId="{549D62BC-ADF9-EE85-6CD4-495C166FD26E}"/>
          </ac:grpSpMkLst>
        </pc:grpChg>
        <pc:grpChg chg="mod">
          <ac:chgData name="IOANNIS CHATZIEFFRAIMIDIS" userId="b961d053ce115571" providerId="LiveId" clId="{EEE8EA51-0644-4221-A89F-49C2277D6B76}" dt="2025-11-07T11:03:51.995" v="4939"/>
          <ac:grpSpMkLst>
            <pc:docMk/>
            <pc:sldMk cId="1742971463" sldId="256"/>
            <ac:grpSpMk id="183" creationId="{FEB28557-4458-6569-7A63-3FC6F3F56BA5}"/>
          </ac:grpSpMkLst>
        </pc:grpChg>
        <pc:grpChg chg="add mod">
          <ac:chgData name="IOANNIS CHATZIEFFRAIMIDIS" userId="b961d053ce115571" providerId="LiveId" clId="{EEE8EA51-0644-4221-A89F-49C2277D6B76}" dt="2025-11-07T11:11:26.604" v="5143" actId="164"/>
          <ac:grpSpMkLst>
            <pc:docMk/>
            <pc:sldMk cId="1742971463" sldId="256"/>
            <ac:grpSpMk id="192" creationId="{6A352CD5-DA7C-5CCE-76ED-5C2ABDCE6F5E}"/>
          </ac:grpSpMkLst>
        </pc:grpChg>
        <pc:grpChg chg="add mod">
          <ac:chgData name="IOANNIS CHATZIEFFRAIMIDIS" userId="b961d053ce115571" providerId="LiveId" clId="{EEE8EA51-0644-4221-A89F-49C2277D6B76}" dt="2025-11-07T11:16:15.652" v="5389" actId="1035"/>
          <ac:grpSpMkLst>
            <pc:docMk/>
            <pc:sldMk cId="1742971463" sldId="256"/>
            <ac:grpSpMk id="196" creationId="{0EA3279B-45E4-2E94-2866-BBB57A766F08}"/>
          </ac:grpSpMkLst>
        </pc:grpChg>
        <pc:grpChg chg="add mod">
          <ac:chgData name="IOANNIS CHATZIEFFRAIMIDIS" userId="b961d053ce115571" providerId="LiveId" clId="{EEE8EA51-0644-4221-A89F-49C2277D6B76}" dt="2025-11-07T11:12:46.693" v="5293" actId="1038"/>
          <ac:grpSpMkLst>
            <pc:docMk/>
            <pc:sldMk cId="1742971463" sldId="256"/>
            <ac:grpSpMk id="197" creationId="{D43B5573-7580-5E83-E34D-B0F2BAB3122E}"/>
          </ac:grpSpMkLst>
        </pc:grpChg>
        <pc:grpChg chg="add mod">
          <ac:chgData name="IOANNIS CHATZIEFFRAIMIDIS" userId="b961d053ce115571" providerId="LiveId" clId="{EEE8EA51-0644-4221-A89F-49C2277D6B76}" dt="2025-11-07T11:16:15.652" v="5389" actId="1035"/>
          <ac:grpSpMkLst>
            <pc:docMk/>
            <pc:sldMk cId="1742971463" sldId="256"/>
            <ac:grpSpMk id="198" creationId="{2C011C49-2D32-75FA-FF17-95067F935027}"/>
          </ac:grpSpMkLst>
        </pc:grpChg>
        <pc:picChg chg="mod">
          <ac:chgData name="IOANNIS CHATZIEFFRAIMIDIS" userId="b961d053ce115571" providerId="LiveId" clId="{EEE8EA51-0644-4221-A89F-49C2277D6B76}" dt="2025-11-07T11:13:31.444" v="5299" actId="1076"/>
          <ac:picMkLst>
            <pc:docMk/>
            <pc:sldMk cId="1742971463" sldId="256"/>
            <ac:picMk id="100" creationId="{EA06A2B8-3B60-E22B-7B5A-66CD45358A5E}"/>
          </ac:picMkLst>
        </pc:picChg>
        <pc:picChg chg="add mod">
          <ac:chgData name="IOANNIS CHATZIEFFRAIMIDIS" userId="b961d053ce115571" providerId="LiveId" clId="{EEE8EA51-0644-4221-A89F-49C2277D6B76}" dt="2025-11-07T10:18:21.938" v="3957" actId="164"/>
          <ac:picMkLst>
            <pc:docMk/>
            <pc:sldMk cId="1742971463" sldId="256"/>
            <ac:picMk id="123" creationId="{7F16AEB5-A6DB-1C03-3E5E-6EE9BE8DC9D2}"/>
          </ac:picMkLst>
        </pc:picChg>
        <pc:picChg chg="add mod">
          <ac:chgData name="IOANNIS CHATZIEFFRAIMIDIS" userId="b961d053ce115571" providerId="LiveId" clId="{EEE8EA51-0644-4221-A89F-49C2277D6B76}" dt="2025-11-07T11:16:15.652" v="5389" actId="1035"/>
          <ac:picMkLst>
            <pc:docMk/>
            <pc:sldMk cId="1742971463" sldId="256"/>
            <ac:picMk id="125" creationId="{24A254E2-6C55-2131-1DE1-27528E6B85A4}"/>
          </ac:picMkLst>
        </pc:picChg>
        <pc:picChg chg="mod">
          <ac:chgData name="IOANNIS CHATZIEFFRAIMIDIS" userId="b961d053ce115571" providerId="LiveId" clId="{EEE8EA51-0644-4221-A89F-49C2277D6B76}" dt="2025-11-07T10:41:45.615" v="4336" actId="165"/>
          <ac:picMkLst>
            <pc:docMk/>
            <pc:sldMk cId="1742971463" sldId="256"/>
            <ac:picMk id="152" creationId="{30FC48AD-7482-C706-4212-E01FD6A25594}"/>
          </ac:picMkLst>
        </pc:picChg>
        <pc:picChg chg="mod">
          <ac:chgData name="IOANNIS CHATZIEFFRAIMIDIS" userId="b961d053ce115571" providerId="LiveId" clId="{EEE8EA51-0644-4221-A89F-49C2277D6B76}" dt="2025-11-07T11:11:06.759" v="5100" actId="164"/>
          <ac:picMkLst>
            <pc:docMk/>
            <pc:sldMk cId="1742971463" sldId="256"/>
            <ac:picMk id="163" creationId="{A56B5092-3ABC-C01F-E4A1-1914E6F7674A}"/>
          </ac:picMkLst>
        </pc:picChg>
        <pc:picChg chg="mod">
          <ac:chgData name="IOANNIS CHATZIEFFRAIMIDIS" userId="b961d053ce115571" providerId="LiveId" clId="{EEE8EA51-0644-4221-A89F-49C2277D6B76}" dt="2025-11-07T11:03:51.995" v="4939"/>
          <ac:picMkLst>
            <pc:docMk/>
            <pc:sldMk cId="1742971463" sldId="256"/>
            <ac:picMk id="181" creationId="{050C48E9-0EBE-CC87-70AD-047F6392E98F}"/>
          </ac:picMkLst>
        </pc:picChg>
        <pc:picChg chg="mod">
          <ac:chgData name="IOANNIS CHATZIEFFRAIMIDIS" userId="b961d053ce115571" providerId="LiveId" clId="{EEE8EA51-0644-4221-A89F-49C2277D6B76}" dt="2025-11-07T11:09:59.287" v="5080"/>
          <ac:picMkLst>
            <pc:docMk/>
            <pc:sldMk cId="1742971463" sldId="256"/>
            <ac:picMk id="193" creationId="{469F058B-2C29-C3DC-CC2B-2F3513016EC2}"/>
          </ac:picMkLst>
        </pc:picChg>
        <pc:cxnChg chg="mod">
          <ac:chgData name="IOANNIS CHATZIEFFRAIMIDIS" userId="b961d053ce115571" providerId="LiveId" clId="{EEE8EA51-0644-4221-A89F-49C2277D6B76}" dt="2025-11-07T11:16:15.652" v="5389" actId="1035"/>
          <ac:cxnSpMkLst>
            <pc:docMk/>
            <pc:sldMk cId="1742971463" sldId="256"/>
            <ac:cxnSpMk id="81" creationId="{7CD096E7-1CE0-2454-570F-068EEE3D13A5}"/>
          </ac:cxnSpMkLst>
        </pc:cxnChg>
        <pc:cxnChg chg="mod">
          <ac:chgData name="IOANNIS CHATZIEFFRAIMIDIS" userId="b961d053ce115571" providerId="LiveId" clId="{EEE8EA51-0644-4221-A89F-49C2277D6B76}" dt="2025-11-07T09:55:05.076" v="3371" actId="14100"/>
          <ac:cxnSpMkLst>
            <pc:docMk/>
            <pc:sldMk cId="1742971463" sldId="256"/>
            <ac:cxnSpMk id="83" creationId="{9B38ED16-781A-78CE-0F54-025146EF962D}"/>
          </ac:cxnSpMkLst>
        </pc:cxnChg>
        <pc:cxnChg chg="mod">
          <ac:chgData name="IOANNIS CHATZIEFFRAIMIDIS" userId="b961d053ce115571" providerId="LiveId" clId="{EEE8EA51-0644-4221-A89F-49C2277D6B76}" dt="2025-11-07T09:35:05.374" v="3269" actId="14100"/>
          <ac:cxnSpMkLst>
            <pc:docMk/>
            <pc:sldMk cId="1742971463" sldId="256"/>
            <ac:cxnSpMk id="85" creationId="{CC9DCF1C-08D3-F5F6-6E9F-C91A348F67CD}"/>
          </ac:cxnSpMkLst>
        </pc:cxnChg>
        <pc:cxnChg chg="mod">
          <ac:chgData name="IOANNIS CHATZIEFFRAIMIDIS" userId="b961d053ce115571" providerId="LiveId" clId="{EEE8EA51-0644-4221-A89F-49C2277D6B76}" dt="2025-11-07T10:16:41.521" v="3851" actId="14100"/>
          <ac:cxnSpMkLst>
            <pc:docMk/>
            <pc:sldMk cId="1742971463" sldId="256"/>
            <ac:cxnSpMk id="91" creationId="{EB0DE31E-E089-8345-32BE-397B16E1F316}"/>
          </ac:cxnSpMkLst>
        </pc:cxnChg>
        <pc:cxnChg chg="add del mod">
          <ac:chgData name="IOANNIS CHATZIEFFRAIMIDIS" userId="b961d053ce115571" providerId="LiveId" clId="{EEE8EA51-0644-4221-A89F-49C2277D6B76}" dt="2025-11-07T10:19:12.858" v="4119" actId="1038"/>
          <ac:cxnSpMkLst>
            <pc:docMk/>
            <pc:sldMk cId="1742971463" sldId="256"/>
            <ac:cxnSpMk id="93" creationId="{E2183DEF-4467-CDF7-EAC5-FFA6759660C5}"/>
          </ac:cxnSpMkLst>
        </pc:cxnChg>
        <pc:cxnChg chg="add del mod">
          <ac:chgData name="IOANNIS CHATZIEFFRAIMIDIS" userId="b961d053ce115571" providerId="LiveId" clId="{EEE8EA51-0644-4221-A89F-49C2277D6B76}" dt="2025-11-07T10:19:01.242" v="4105" actId="14100"/>
          <ac:cxnSpMkLst>
            <pc:docMk/>
            <pc:sldMk cId="1742971463" sldId="256"/>
            <ac:cxnSpMk id="95" creationId="{05CE6C95-1DDD-96DE-B1E2-AFCBDDBD90B3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84948" y="2651323"/>
            <a:ext cx="16829405" cy="5640152"/>
          </a:xfrm>
        </p:spPr>
        <p:txBody>
          <a:bodyPr anchor="b"/>
          <a:lstStyle>
            <a:lvl1pPr algn="ctr">
              <a:defRPr sz="12992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74913" y="8508981"/>
            <a:ext cx="14849475" cy="3911355"/>
          </a:xfrm>
        </p:spPr>
        <p:txBody>
          <a:bodyPr/>
          <a:lstStyle>
            <a:lvl1pPr marL="0" indent="0" algn="ctr">
              <a:buNone/>
              <a:defRPr sz="5197"/>
            </a:lvl1pPr>
            <a:lvl2pPr marL="989975" indent="0" algn="ctr">
              <a:buNone/>
              <a:defRPr sz="4331"/>
            </a:lvl2pPr>
            <a:lvl3pPr marL="1979950" indent="0" algn="ctr">
              <a:buNone/>
              <a:defRPr sz="3898"/>
            </a:lvl3pPr>
            <a:lvl4pPr marL="2969925" indent="0" algn="ctr">
              <a:buNone/>
              <a:defRPr sz="3464"/>
            </a:lvl4pPr>
            <a:lvl5pPr marL="3959901" indent="0" algn="ctr">
              <a:buNone/>
              <a:defRPr sz="3464"/>
            </a:lvl5pPr>
            <a:lvl6pPr marL="4949876" indent="0" algn="ctr">
              <a:buNone/>
              <a:defRPr sz="3464"/>
            </a:lvl6pPr>
            <a:lvl7pPr marL="5939851" indent="0" algn="ctr">
              <a:buNone/>
              <a:defRPr sz="3464"/>
            </a:lvl7pPr>
            <a:lvl8pPr marL="6929826" indent="0" algn="ctr">
              <a:buNone/>
              <a:defRPr sz="3464"/>
            </a:lvl8pPr>
            <a:lvl9pPr marL="7919801" indent="0" algn="ctr">
              <a:buNone/>
              <a:defRPr sz="3464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602701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27738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4168875" y="862524"/>
            <a:ext cx="4269224" cy="13729122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61203" y="862524"/>
            <a:ext cx="12560181" cy="13729122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37140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218048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50891" y="4038864"/>
            <a:ext cx="17076896" cy="6738931"/>
          </a:xfrm>
        </p:spPr>
        <p:txBody>
          <a:bodyPr anchor="b"/>
          <a:lstStyle>
            <a:lvl1pPr>
              <a:defRPr sz="12992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50891" y="10841548"/>
            <a:ext cx="17076896" cy="3543845"/>
          </a:xfrm>
        </p:spPr>
        <p:txBody>
          <a:bodyPr/>
          <a:lstStyle>
            <a:lvl1pPr marL="0" indent="0">
              <a:buNone/>
              <a:defRPr sz="5197">
                <a:solidFill>
                  <a:schemeClr val="tx1"/>
                </a:solidFill>
              </a:defRPr>
            </a:lvl1pPr>
            <a:lvl2pPr marL="989975" indent="0">
              <a:buNone/>
              <a:defRPr sz="4331">
                <a:solidFill>
                  <a:schemeClr val="tx1">
                    <a:tint val="75000"/>
                  </a:schemeClr>
                </a:solidFill>
              </a:defRPr>
            </a:lvl2pPr>
            <a:lvl3pPr marL="1979950" indent="0">
              <a:buNone/>
              <a:defRPr sz="3898">
                <a:solidFill>
                  <a:schemeClr val="tx1">
                    <a:tint val="75000"/>
                  </a:schemeClr>
                </a:solidFill>
              </a:defRPr>
            </a:lvl3pPr>
            <a:lvl4pPr marL="2969925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4pPr>
            <a:lvl5pPr marL="395990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5pPr>
            <a:lvl6pPr marL="4949876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6pPr>
            <a:lvl7pPr marL="593985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7pPr>
            <a:lvl8pPr marL="6929826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8pPr>
            <a:lvl9pPr marL="7919801" indent="0">
              <a:buNone/>
              <a:defRPr sz="34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47521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61202" y="4312617"/>
            <a:ext cx="8414703" cy="10279029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023395" y="4312617"/>
            <a:ext cx="8414703" cy="10279029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301402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862527"/>
            <a:ext cx="17076896" cy="3131336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3783" y="3971359"/>
            <a:ext cx="8376031" cy="1946301"/>
          </a:xfrm>
        </p:spPr>
        <p:txBody>
          <a:bodyPr anchor="b"/>
          <a:lstStyle>
            <a:lvl1pPr marL="0" indent="0">
              <a:buNone/>
              <a:defRPr sz="5197" b="1"/>
            </a:lvl1pPr>
            <a:lvl2pPr marL="989975" indent="0">
              <a:buNone/>
              <a:defRPr sz="4331" b="1"/>
            </a:lvl2pPr>
            <a:lvl3pPr marL="1979950" indent="0">
              <a:buNone/>
              <a:defRPr sz="3898" b="1"/>
            </a:lvl3pPr>
            <a:lvl4pPr marL="2969925" indent="0">
              <a:buNone/>
              <a:defRPr sz="3464" b="1"/>
            </a:lvl4pPr>
            <a:lvl5pPr marL="3959901" indent="0">
              <a:buNone/>
              <a:defRPr sz="3464" b="1"/>
            </a:lvl5pPr>
            <a:lvl6pPr marL="4949876" indent="0">
              <a:buNone/>
              <a:defRPr sz="3464" b="1"/>
            </a:lvl6pPr>
            <a:lvl7pPr marL="5939851" indent="0">
              <a:buNone/>
              <a:defRPr sz="3464" b="1"/>
            </a:lvl7pPr>
            <a:lvl8pPr marL="6929826" indent="0">
              <a:buNone/>
              <a:defRPr sz="3464" b="1"/>
            </a:lvl8pPr>
            <a:lvl9pPr marL="7919801" indent="0">
              <a:buNone/>
              <a:defRPr sz="3464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63783" y="5917660"/>
            <a:ext cx="8376031" cy="8703987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023397" y="3971359"/>
            <a:ext cx="8417281" cy="1946301"/>
          </a:xfrm>
        </p:spPr>
        <p:txBody>
          <a:bodyPr anchor="b"/>
          <a:lstStyle>
            <a:lvl1pPr marL="0" indent="0">
              <a:buNone/>
              <a:defRPr sz="5197" b="1"/>
            </a:lvl1pPr>
            <a:lvl2pPr marL="989975" indent="0">
              <a:buNone/>
              <a:defRPr sz="4331" b="1"/>
            </a:lvl2pPr>
            <a:lvl3pPr marL="1979950" indent="0">
              <a:buNone/>
              <a:defRPr sz="3898" b="1"/>
            </a:lvl3pPr>
            <a:lvl4pPr marL="2969925" indent="0">
              <a:buNone/>
              <a:defRPr sz="3464" b="1"/>
            </a:lvl4pPr>
            <a:lvl5pPr marL="3959901" indent="0">
              <a:buNone/>
              <a:defRPr sz="3464" b="1"/>
            </a:lvl5pPr>
            <a:lvl6pPr marL="4949876" indent="0">
              <a:buNone/>
              <a:defRPr sz="3464" b="1"/>
            </a:lvl6pPr>
            <a:lvl7pPr marL="5939851" indent="0">
              <a:buNone/>
              <a:defRPr sz="3464" b="1"/>
            </a:lvl7pPr>
            <a:lvl8pPr marL="6929826" indent="0">
              <a:buNone/>
              <a:defRPr sz="3464" b="1"/>
            </a:lvl8pPr>
            <a:lvl9pPr marL="7919801" indent="0">
              <a:buNone/>
              <a:defRPr sz="3464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023397" y="5917660"/>
            <a:ext cx="8417281" cy="8703987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11782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19413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5806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1080029"/>
            <a:ext cx="6385790" cy="3780102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417281" y="2332567"/>
            <a:ext cx="10023396" cy="11512811"/>
          </a:xfrm>
        </p:spPr>
        <p:txBody>
          <a:bodyPr/>
          <a:lstStyle>
            <a:lvl1pPr>
              <a:defRPr sz="6929"/>
            </a:lvl1pPr>
            <a:lvl2pPr>
              <a:defRPr sz="6063"/>
            </a:lvl2pPr>
            <a:lvl3pPr>
              <a:defRPr sz="5197"/>
            </a:lvl3pPr>
            <a:lvl4pPr>
              <a:defRPr sz="4331"/>
            </a:lvl4pPr>
            <a:lvl5pPr>
              <a:defRPr sz="4331"/>
            </a:lvl5pPr>
            <a:lvl6pPr>
              <a:defRPr sz="4331"/>
            </a:lvl6pPr>
            <a:lvl7pPr>
              <a:defRPr sz="4331"/>
            </a:lvl7pPr>
            <a:lvl8pPr>
              <a:defRPr sz="4331"/>
            </a:lvl8pPr>
            <a:lvl9pPr>
              <a:defRPr sz="4331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63781" y="4860131"/>
            <a:ext cx="6385790" cy="9003995"/>
          </a:xfrm>
        </p:spPr>
        <p:txBody>
          <a:bodyPr/>
          <a:lstStyle>
            <a:lvl1pPr marL="0" indent="0">
              <a:buNone/>
              <a:defRPr sz="3464"/>
            </a:lvl1pPr>
            <a:lvl2pPr marL="989975" indent="0">
              <a:buNone/>
              <a:defRPr sz="3031"/>
            </a:lvl2pPr>
            <a:lvl3pPr marL="1979950" indent="0">
              <a:buNone/>
              <a:defRPr sz="2598"/>
            </a:lvl3pPr>
            <a:lvl4pPr marL="2969925" indent="0">
              <a:buNone/>
              <a:defRPr sz="2165"/>
            </a:lvl4pPr>
            <a:lvl5pPr marL="3959901" indent="0">
              <a:buNone/>
              <a:defRPr sz="2165"/>
            </a:lvl5pPr>
            <a:lvl6pPr marL="4949876" indent="0">
              <a:buNone/>
              <a:defRPr sz="2165"/>
            </a:lvl6pPr>
            <a:lvl7pPr marL="5939851" indent="0">
              <a:buNone/>
              <a:defRPr sz="2165"/>
            </a:lvl7pPr>
            <a:lvl8pPr marL="6929826" indent="0">
              <a:buNone/>
              <a:defRPr sz="2165"/>
            </a:lvl8pPr>
            <a:lvl9pPr marL="7919801" indent="0">
              <a:buNone/>
              <a:defRPr sz="2165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1907296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63781" y="1080029"/>
            <a:ext cx="6385790" cy="3780102"/>
          </a:xfrm>
        </p:spPr>
        <p:txBody>
          <a:bodyPr anchor="b"/>
          <a:lstStyle>
            <a:lvl1pPr>
              <a:defRPr sz="6929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417281" y="2332567"/>
            <a:ext cx="10023396" cy="11512811"/>
          </a:xfrm>
        </p:spPr>
        <p:txBody>
          <a:bodyPr anchor="t"/>
          <a:lstStyle>
            <a:lvl1pPr marL="0" indent="0">
              <a:buNone/>
              <a:defRPr sz="6929"/>
            </a:lvl1pPr>
            <a:lvl2pPr marL="989975" indent="0">
              <a:buNone/>
              <a:defRPr sz="6063"/>
            </a:lvl2pPr>
            <a:lvl3pPr marL="1979950" indent="0">
              <a:buNone/>
              <a:defRPr sz="5197"/>
            </a:lvl3pPr>
            <a:lvl4pPr marL="2969925" indent="0">
              <a:buNone/>
              <a:defRPr sz="4331"/>
            </a:lvl4pPr>
            <a:lvl5pPr marL="3959901" indent="0">
              <a:buNone/>
              <a:defRPr sz="4331"/>
            </a:lvl5pPr>
            <a:lvl6pPr marL="4949876" indent="0">
              <a:buNone/>
              <a:defRPr sz="4331"/>
            </a:lvl6pPr>
            <a:lvl7pPr marL="5939851" indent="0">
              <a:buNone/>
              <a:defRPr sz="4331"/>
            </a:lvl7pPr>
            <a:lvl8pPr marL="6929826" indent="0">
              <a:buNone/>
              <a:defRPr sz="4331"/>
            </a:lvl8pPr>
            <a:lvl9pPr marL="7919801" indent="0">
              <a:buNone/>
              <a:defRPr sz="4331"/>
            </a:lvl9pPr>
          </a:lstStyle>
          <a:p>
            <a:r>
              <a:rPr lang="el-GR"/>
              <a:t>Κάντε κλικ στο εικονίδιο για να προσθέσετε εικόνα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63781" y="4860131"/>
            <a:ext cx="6385790" cy="9003995"/>
          </a:xfrm>
        </p:spPr>
        <p:txBody>
          <a:bodyPr/>
          <a:lstStyle>
            <a:lvl1pPr marL="0" indent="0">
              <a:buNone/>
              <a:defRPr sz="3464"/>
            </a:lvl1pPr>
            <a:lvl2pPr marL="989975" indent="0">
              <a:buNone/>
              <a:defRPr sz="3031"/>
            </a:lvl2pPr>
            <a:lvl3pPr marL="1979950" indent="0">
              <a:buNone/>
              <a:defRPr sz="2598"/>
            </a:lvl3pPr>
            <a:lvl4pPr marL="2969925" indent="0">
              <a:buNone/>
              <a:defRPr sz="2165"/>
            </a:lvl4pPr>
            <a:lvl5pPr marL="3959901" indent="0">
              <a:buNone/>
              <a:defRPr sz="2165"/>
            </a:lvl5pPr>
            <a:lvl6pPr marL="4949876" indent="0">
              <a:buNone/>
              <a:defRPr sz="2165"/>
            </a:lvl6pPr>
            <a:lvl7pPr marL="5939851" indent="0">
              <a:buNone/>
              <a:defRPr sz="2165"/>
            </a:lvl7pPr>
            <a:lvl8pPr marL="6929826" indent="0">
              <a:buNone/>
              <a:defRPr sz="2165"/>
            </a:lvl8pPr>
            <a:lvl9pPr marL="7919801" indent="0">
              <a:buNone/>
              <a:defRPr sz="2165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1753785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61202" y="862527"/>
            <a:ext cx="17076896" cy="3131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61202" y="4312617"/>
            <a:ext cx="17076896" cy="102790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61202" y="15015410"/>
            <a:ext cx="4454843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C63F7-925C-41A1-BB4A-0E79ED06C004}" type="datetimeFigureOut">
              <a:rPr lang="el-GR" smtClean="0"/>
              <a:t>20/11/2025</a:t>
            </a:fld>
            <a:endParaRPr lang="el-G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558518" y="15015410"/>
            <a:ext cx="6682264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983255" y="15015410"/>
            <a:ext cx="4454843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9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0318F-AF6F-435E-9020-42A1C4C7F6B5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92492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1979950" rtl="0" eaLnBrk="1" latinLnBrk="0" hangingPunct="1">
        <a:lnSpc>
          <a:spcPct val="90000"/>
        </a:lnSpc>
        <a:spcBef>
          <a:spcPct val="0"/>
        </a:spcBef>
        <a:buNone/>
        <a:defRPr sz="952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4988" indent="-494988" algn="l" defTabSz="1979950" rtl="0" eaLnBrk="1" latinLnBrk="0" hangingPunct="1">
        <a:lnSpc>
          <a:spcPct val="90000"/>
        </a:lnSpc>
        <a:spcBef>
          <a:spcPts val="2165"/>
        </a:spcBef>
        <a:buFont typeface="Arial" panose="020B0604020202020204" pitchFamily="34" charset="0"/>
        <a:buChar char="•"/>
        <a:defRPr sz="6063" kern="1200">
          <a:solidFill>
            <a:schemeClr val="tx1"/>
          </a:solidFill>
          <a:latin typeface="+mn-lt"/>
          <a:ea typeface="+mn-ea"/>
          <a:cs typeface="+mn-cs"/>
        </a:defRPr>
      </a:lvl1pPr>
      <a:lvl2pPr marL="148496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5197" kern="1200">
          <a:solidFill>
            <a:schemeClr val="tx1"/>
          </a:solidFill>
          <a:latin typeface="+mn-lt"/>
          <a:ea typeface="+mn-ea"/>
          <a:cs typeface="+mn-cs"/>
        </a:defRPr>
      </a:lvl2pPr>
      <a:lvl3pPr marL="2474938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4331" kern="1200">
          <a:solidFill>
            <a:schemeClr val="tx1"/>
          </a:solidFill>
          <a:latin typeface="+mn-lt"/>
          <a:ea typeface="+mn-ea"/>
          <a:cs typeface="+mn-cs"/>
        </a:defRPr>
      </a:lvl3pPr>
      <a:lvl4pPr marL="346491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4pPr>
      <a:lvl5pPr marL="4454888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5pPr>
      <a:lvl6pPr marL="5444863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6pPr>
      <a:lvl7pPr marL="6434839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7pPr>
      <a:lvl8pPr marL="7424814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8pPr>
      <a:lvl9pPr marL="8414789" indent="-494988" algn="l" defTabSz="197995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89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1pPr>
      <a:lvl2pPr marL="989975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2pPr>
      <a:lvl3pPr marL="1979950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3pPr>
      <a:lvl4pPr marL="2969925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4pPr>
      <a:lvl5pPr marL="395990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5pPr>
      <a:lvl6pPr marL="4949876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6pPr>
      <a:lvl7pPr marL="593985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7pPr>
      <a:lvl8pPr marL="6929826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8pPr>
      <a:lvl9pPr marL="7919801" algn="l" defTabSz="1979950" rtl="0" eaLnBrk="1" latinLnBrk="0" hangingPunct="1">
        <a:defRPr sz="389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1" name="Ευθεία γραμμή σύνδεσης 80">
            <a:extLst>
              <a:ext uri="{FF2B5EF4-FFF2-40B4-BE49-F238E27FC236}">
                <a16:creationId xmlns:a16="http://schemas.microsoft.com/office/drawing/2014/main" id="{7CD096E7-1CE0-2454-570F-068EEE3D13A5}"/>
              </a:ext>
            </a:extLst>
          </p:cNvPr>
          <p:cNvCxnSpPr>
            <a:cxnSpLocks/>
          </p:cNvCxnSpPr>
          <p:nvPr/>
        </p:nvCxnSpPr>
        <p:spPr>
          <a:xfrm>
            <a:off x="362778" y="8449033"/>
            <a:ext cx="0" cy="3240909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24929E74-0661-C574-EDCD-6A644CDEBB1D}"/>
              </a:ext>
            </a:extLst>
          </p:cNvPr>
          <p:cNvSpPr txBox="1"/>
          <p:nvPr/>
        </p:nvSpPr>
        <p:spPr>
          <a:xfrm rot="16200000">
            <a:off x="-1377157" y="9930837"/>
            <a:ext cx="3240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irel</a:t>
            </a:r>
            <a:endParaRPr lang="el-GR" sz="13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Ευθεία γραμμή σύνδεσης 82">
            <a:extLst>
              <a:ext uri="{FF2B5EF4-FFF2-40B4-BE49-F238E27FC236}">
                <a16:creationId xmlns:a16="http://schemas.microsoft.com/office/drawing/2014/main" id="{9B38ED16-781A-78CE-0F54-025146EF962D}"/>
              </a:ext>
            </a:extLst>
          </p:cNvPr>
          <p:cNvCxnSpPr>
            <a:cxnSpLocks/>
          </p:cNvCxnSpPr>
          <p:nvPr/>
        </p:nvCxnSpPr>
        <p:spPr>
          <a:xfrm flipV="1">
            <a:off x="401313" y="4411343"/>
            <a:ext cx="0" cy="3575723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0B4128AB-6F4A-7BF6-40E8-078E37511D39}"/>
              </a:ext>
            </a:extLst>
          </p:cNvPr>
          <p:cNvSpPr txBox="1"/>
          <p:nvPr/>
        </p:nvSpPr>
        <p:spPr>
          <a:xfrm rot="16200000">
            <a:off x="-1560841" y="6059322"/>
            <a:ext cx="35477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latibelle</a:t>
            </a:r>
            <a:endParaRPr lang="el-G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Ευθεία γραμμή σύνδεσης 84">
            <a:extLst>
              <a:ext uri="{FF2B5EF4-FFF2-40B4-BE49-F238E27FC236}">
                <a16:creationId xmlns:a16="http://schemas.microsoft.com/office/drawing/2014/main" id="{CC9DCF1C-08D3-F5F6-6E9F-C91A348F67CD}"/>
              </a:ext>
            </a:extLst>
          </p:cNvPr>
          <p:cNvCxnSpPr>
            <a:cxnSpLocks/>
          </p:cNvCxnSpPr>
          <p:nvPr/>
        </p:nvCxnSpPr>
        <p:spPr>
          <a:xfrm>
            <a:off x="551039" y="3865153"/>
            <a:ext cx="5351433" cy="7558"/>
          </a:xfrm>
          <a:prstGeom prst="line">
            <a:avLst/>
          </a:prstGeom>
          <a:ln w="5715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9F905FCD-DB4B-E09E-D3CB-A4462F3F4EE0}"/>
              </a:ext>
            </a:extLst>
          </p:cNvPr>
          <p:cNvSpPr txBox="1"/>
          <p:nvPr/>
        </p:nvSpPr>
        <p:spPr>
          <a:xfrm>
            <a:off x="551039" y="3497085"/>
            <a:ext cx="5351433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siological parameters</a:t>
            </a:r>
            <a:endParaRPr lang="el-GR" sz="1600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Ευθεία γραμμή σύνδεσης 90">
            <a:extLst>
              <a:ext uri="{FF2B5EF4-FFF2-40B4-BE49-F238E27FC236}">
                <a16:creationId xmlns:a16="http://schemas.microsoft.com/office/drawing/2014/main" id="{EB0DE31E-E089-8345-32BE-397B16E1F316}"/>
              </a:ext>
            </a:extLst>
          </p:cNvPr>
          <p:cNvCxnSpPr>
            <a:cxnSpLocks/>
          </p:cNvCxnSpPr>
          <p:nvPr/>
        </p:nvCxnSpPr>
        <p:spPr>
          <a:xfrm>
            <a:off x="6527432" y="3865154"/>
            <a:ext cx="12664334" cy="0"/>
          </a:xfrm>
          <a:prstGeom prst="line">
            <a:avLst/>
          </a:prstGeom>
          <a:ln w="57150">
            <a:solidFill>
              <a:schemeClr val="accent5">
                <a:lumMod val="75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DF8FFC27-3C27-6FAB-13CA-344F319EF89F}"/>
              </a:ext>
            </a:extLst>
          </p:cNvPr>
          <p:cNvSpPr txBox="1"/>
          <p:nvPr/>
        </p:nvSpPr>
        <p:spPr>
          <a:xfrm>
            <a:off x="6481711" y="3497085"/>
            <a:ext cx="12664334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accent5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uit quality traits</a:t>
            </a:r>
            <a:endParaRPr lang="el-GR" sz="1600" b="1" dirty="0">
              <a:solidFill>
                <a:schemeClr val="accent5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Ευθεία γραμμή σύνδεσης 92">
            <a:extLst>
              <a:ext uri="{FF2B5EF4-FFF2-40B4-BE49-F238E27FC236}">
                <a16:creationId xmlns:a16="http://schemas.microsoft.com/office/drawing/2014/main" id="{E2183DEF-4467-CDF7-EAC5-FFA6759660C5}"/>
              </a:ext>
            </a:extLst>
          </p:cNvPr>
          <p:cNvCxnSpPr>
            <a:cxnSpLocks/>
          </p:cNvCxnSpPr>
          <p:nvPr/>
        </p:nvCxnSpPr>
        <p:spPr>
          <a:xfrm>
            <a:off x="7289433" y="4197594"/>
            <a:ext cx="5695049" cy="0"/>
          </a:xfrm>
          <a:prstGeom prst="line">
            <a:avLst/>
          </a:prstGeom>
          <a:ln w="571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5" name="Ευθεία γραμμή σύνδεσης 94">
            <a:extLst>
              <a:ext uri="{FF2B5EF4-FFF2-40B4-BE49-F238E27FC236}">
                <a16:creationId xmlns:a16="http://schemas.microsoft.com/office/drawing/2014/main" id="{05CE6C95-1DDD-96DE-B1E2-AFCBDDBD90B3}"/>
              </a:ext>
            </a:extLst>
          </p:cNvPr>
          <p:cNvCxnSpPr>
            <a:cxnSpLocks/>
          </p:cNvCxnSpPr>
          <p:nvPr/>
        </p:nvCxnSpPr>
        <p:spPr>
          <a:xfrm>
            <a:off x="14118029" y="4194797"/>
            <a:ext cx="5535817" cy="2797"/>
          </a:xfrm>
          <a:prstGeom prst="line">
            <a:avLst/>
          </a:prstGeom>
          <a:ln w="571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81A3591E-67CA-B3CC-00B6-2ABEB931EED7}"/>
              </a:ext>
            </a:extLst>
          </p:cNvPr>
          <p:cNvSpPr txBox="1"/>
          <p:nvPr/>
        </p:nvSpPr>
        <p:spPr>
          <a:xfrm>
            <a:off x="180173" y="3862971"/>
            <a:ext cx="669746" cy="4787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Palatino Linotype" panose="02040502050505030304" pitchFamily="18" charset="0"/>
                <a:cs typeface="Arial" panose="020B0604020202020204" pitchFamily="34" charset="0"/>
              </a:rPr>
              <a:t>(a)</a:t>
            </a:r>
            <a:endParaRPr lang="el-GR" sz="14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1E18749-065F-084D-4EBC-F930E2190CA1}"/>
              </a:ext>
            </a:extLst>
          </p:cNvPr>
          <p:cNvSpPr txBox="1"/>
          <p:nvPr/>
        </p:nvSpPr>
        <p:spPr>
          <a:xfrm>
            <a:off x="6181735" y="3879066"/>
            <a:ext cx="669746" cy="4787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Palatino Linotype" panose="02040502050505030304" pitchFamily="18" charset="0"/>
                <a:cs typeface="Arial" panose="020B0604020202020204" pitchFamily="34" charset="0"/>
              </a:rPr>
              <a:t>(b)</a:t>
            </a:r>
            <a:endParaRPr lang="el-GR" sz="24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100" name="Εικόνα 99">
            <a:extLst>
              <a:ext uri="{FF2B5EF4-FFF2-40B4-BE49-F238E27FC236}">
                <a16:creationId xmlns:a16="http://schemas.microsoft.com/office/drawing/2014/main" id="{EA06A2B8-3B60-E22B-7B5A-66CD45358A5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6000" t="4875" r="37299" b="5329"/>
          <a:stretch>
            <a:fillRect/>
          </a:stretch>
        </p:blipFill>
        <p:spPr>
          <a:xfrm rot="5400000">
            <a:off x="18940197" y="3137580"/>
            <a:ext cx="180308" cy="1231050"/>
          </a:xfrm>
          <a:prstGeom prst="rect">
            <a:avLst/>
          </a:prstGeom>
        </p:spPr>
      </p:pic>
      <p:sp>
        <p:nvSpPr>
          <p:cNvPr id="101" name="TextBox 100">
            <a:extLst>
              <a:ext uri="{FF2B5EF4-FFF2-40B4-BE49-F238E27FC236}">
                <a16:creationId xmlns:a16="http://schemas.microsoft.com/office/drawing/2014/main" id="{275E5A65-F95E-BAF8-A49A-B039D6777EC9}"/>
              </a:ext>
            </a:extLst>
          </p:cNvPr>
          <p:cNvSpPr txBox="1"/>
          <p:nvPr/>
        </p:nvSpPr>
        <p:spPr>
          <a:xfrm>
            <a:off x="18414826" y="3483462"/>
            <a:ext cx="4719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lang="el-G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C83DCC4-49D6-E59E-3A35-F9E913BC9B7C}"/>
              </a:ext>
            </a:extLst>
          </p:cNvPr>
          <p:cNvSpPr txBox="1"/>
          <p:nvPr/>
        </p:nvSpPr>
        <p:spPr>
          <a:xfrm>
            <a:off x="19248265" y="3476103"/>
            <a:ext cx="4719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ax</a:t>
            </a:r>
            <a:endParaRPr lang="el-GR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BE57A75-D152-854A-2138-6872173EEEAB}"/>
              </a:ext>
            </a:extLst>
          </p:cNvPr>
          <p:cNvSpPr txBox="1"/>
          <p:nvPr/>
        </p:nvSpPr>
        <p:spPr>
          <a:xfrm>
            <a:off x="7348011" y="3923388"/>
            <a:ext cx="56819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0 LEAF/ FRUIT</a:t>
            </a:r>
            <a:endParaRPr lang="el-G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BD221D-4EDA-3672-0866-315227EA4C4D}"/>
              </a:ext>
            </a:extLst>
          </p:cNvPr>
          <p:cNvSpPr txBox="1"/>
          <p:nvPr/>
        </p:nvSpPr>
        <p:spPr>
          <a:xfrm>
            <a:off x="14118029" y="3917798"/>
            <a:ext cx="52919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50 LEAF/ FRUIT</a:t>
            </a:r>
            <a:endParaRPr lang="el-G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3" name="Ομάδα 132">
            <a:extLst>
              <a:ext uri="{FF2B5EF4-FFF2-40B4-BE49-F238E27FC236}">
                <a16:creationId xmlns:a16="http://schemas.microsoft.com/office/drawing/2014/main" id="{A17F5638-01F9-6E1F-0D46-AC779938475C}"/>
              </a:ext>
            </a:extLst>
          </p:cNvPr>
          <p:cNvGrpSpPr/>
          <p:nvPr/>
        </p:nvGrpSpPr>
        <p:grpSpPr>
          <a:xfrm>
            <a:off x="314835" y="3650430"/>
            <a:ext cx="5879968" cy="4465445"/>
            <a:chOff x="330075" y="226892"/>
            <a:chExt cx="5879968" cy="4465445"/>
          </a:xfrm>
        </p:grpSpPr>
        <p:grpSp>
          <p:nvGrpSpPr>
            <p:cNvPr id="120" name="Ομάδα 119">
              <a:extLst>
                <a:ext uri="{FF2B5EF4-FFF2-40B4-BE49-F238E27FC236}">
                  <a16:creationId xmlns:a16="http://schemas.microsoft.com/office/drawing/2014/main" id="{915BCD9F-E109-9D1E-2D4A-B0A5D2AA0CAA}"/>
                </a:ext>
              </a:extLst>
            </p:cNvPr>
            <p:cNvGrpSpPr/>
            <p:nvPr/>
          </p:nvGrpSpPr>
          <p:grpSpPr>
            <a:xfrm>
              <a:off x="330075" y="226892"/>
              <a:ext cx="5874972" cy="4465445"/>
              <a:chOff x="459247" y="1025131"/>
              <a:chExt cx="5874972" cy="4465445"/>
            </a:xfrm>
          </p:grpSpPr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C22D3DAB-B010-09B1-E1D3-815EFDFF04D2}"/>
                  </a:ext>
                </a:extLst>
              </p:cNvPr>
              <p:cNvSpPr txBox="1"/>
              <p:nvPr/>
            </p:nvSpPr>
            <p:spPr>
              <a:xfrm>
                <a:off x="459247" y="1762183"/>
                <a:ext cx="716693" cy="372839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pt-PT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i</a:t>
                </a:r>
                <a:endParaRPr lang="pt-PT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pdl</a:t>
                </a: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leaf</a:t>
                </a: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UE</a:t>
                </a:r>
              </a:p>
              <a:p>
                <a:pPr algn="ctr">
                  <a:lnSpc>
                    <a:spcPct val="200000"/>
                  </a:lnSpc>
                </a:pPr>
                <a:r>
                  <a:rPr lang="el-G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ΦΠ</a:t>
                </a: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I</a:t>
                </a: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AD</a:t>
                </a:r>
              </a:p>
              <a:p>
                <a:pPr algn="ctr">
                  <a:lnSpc>
                    <a:spcPct val="2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I</a:t>
                </a:r>
                <a:endParaRPr 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8737283A-1191-DE6F-598B-AEE0E8A6634E}"/>
                  </a:ext>
                </a:extLst>
              </p:cNvPr>
              <p:cNvSpPr txBox="1"/>
              <p:nvPr/>
            </p:nvSpPr>
            <p:spPr>
              <a:xfrm rot="16200000">
                <a:off x="3147909" y="-1317445"/>
                <a:ext cx="843733" cy="5528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i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pdl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leaf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UE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lnSpc>
                    <a:spcPct val="300000"/>
                  </a:lnSpc>
                </a:pPr>
                <a:r>
                  <a:rPr lang="el-G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ΦΠ</a:t>
                </a: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II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AD</a:t>
                </a:r>
              </a:p>
              <a:p>
                <a:pPr>
                  <a:lnSpc>
                    <a:spcPct val="30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AI</a:t>
                </a:r>
                <a:endParaRPr 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23" name="Εικόνα 122">
              <a:extLst>
                <a:ext uri="{FF2B5EF4-FFF2-40B4-BE49-F238E27FC236}">
                  <a16:creationId xmlns:a16="http://schemas.microsoft.com/office/drawing/2014/main" id="{7F16AEB5-A6DB-1C03-3E5E-6EE9BE8DC9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70569" y="1125047"/>
              <a:ext cx="5239474" cy="3497627"/>
            </a:xfrm>
            <a:prstGeom prst="rect">
              <a:avLst/>
            </a:prstGeom>
          </p:spPr>
        </p:pic>
      </p:grpSp>
      <p:sp>
        <p:nvSpPr>
          <p:cNvPr id="124" name="Ορθογώνιο 123">
            <a:extLst>
              <a:ext uri="{FF2B5EF4-FFF2-40B4-BE49-F238E27FC236}">
                <a16:creationId xmlns:a16="http://schemas.microsoft.com/office/drawing/2014/main" id="{680EA563-0F65-6F60-C462-361B873955F0}"/>
              </a:ext>
            </a:extLst>
          </p:cNvPr>
          <p:cNvSpPr/>
          <p:nvPr/>
        </p:nvSpPr>
        <p:spPr>
          <a:xfrm>
            <a:off x="964219" y="4545554"/>
            <a:ext cx="5240828" cy="35311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pic>
        <p:nvPicPr>
          <p:cNvPr id="125" name="Εικόνα 124">
            <a:extLst>
              <a:ext uri="{FF2B5EF4-FFF2-40B4-BE49-F238E27FC236}">
                <a16:creationId xmlns:a16="http://schemas.microsoft.com/office/drawing/2014/main" id="{24A254E2-6C55-2131-1DE1-27528E6B85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4219" y="8406909"/>
            <a:ext cx="5240828" cy="3531136"/>
          </a:xfrm>
          <a:prstGeom prst="rect">
            <a:avLst/>
          </a:prstGeom>
        </p:spPr>
      </p:pic>
      <p:grpSp>
        <p:nvGrpSpPr>
          <p:cNvPr id="126" name="Ομάδα 125">
            <a:extLst>
              <a:ext uri="{FF2B5EF4-FFF2-40B4-BE49-F238E27FC236}">
                <a16:creationId xmlns:a16="http://schemas.microsoft.com/office/drawing/2014/main" id="{BB7B6F34-4955-5A54-323C-EE9AB9EA70B8}"/>
              </a:ext>
            </a:extLst>
          </p:cNvPr>
          <p:cNvGrpSpPr/>
          <p:nvPr/>
        </p:nvGrpSpPr>
        <p:grpSpPr>
          <a:xfrm>
            <a:off x="330077" y="8209654"/>
            <a:ext cx="5892555" cy="4572447"/>
            <a:chOff x="459247" y="1762183"/>
            <a:chExt cx="5892555" cy="4572447"/>
          </a:xfrm>
        </p:grpSpPr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B3BDB3AE-AFD8-81E7-A356-25A7A64618AD}"/>
                </a:ext>
              </a:extLst>
            </p:cNvPr>
            <p:cNvSpPr txBox="1"/>
            <p:nvPr/>
          </p:nvSpPr>
          <p:spPr>
            <a:xfrm>
              <a:off x="459247" y="1762183"/>
              <a:ext cx="716693" cy="37283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pt-PT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s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  <a:endParaRPr lang="pt-PT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pdl</a:t>
              </a: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leaf</a:t>
              </a: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UE</a:t>
              </a:r>
            </a:p>
            <a:p>
              <a:pPr algn="ctr">
                <a:lnSpc>
                  <a:spcPct val="200000"/>
                </a:lnSpc>
              </a:pP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ΦΠ</a:t>
              </a: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I</a:t>
              </a: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PAD</a:t>
              </a:r>
            </a:p>
            <a:p>
              <a:pPr algn="ctr">
                <a:lnSpc>
                  <a:spcPct val="2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AI</a:t>
              </a:r>
              <a:endParaRPr 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CA39D0C9-0FFA-28D7-FD01-8CBC6105EF1B}"/>
                </a:ext>
              </a:extLst>
            </p:cNvPr>
            <p:cNvSpPr txBox="1"/>
            <p:nvPr/>
          </p:nvSpPr>
          <p:spPr>
            <a:xfrm rot="16200000">
              <a:off x="3165492" y="3148321"/>
              <a:ext cx="843733" cy="5528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s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i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pdl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leaf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UE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300000"/>
                </a:lnSpc>
              </a:pP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ΦΠ</a:t>
              </a: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II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PAD</a:t>
              </a:r>
            </a:p>
            <a:p>
              <a:pPr algn="r">
                <a:lnSpc>
                  <a:spcPct val="30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AI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9" name="Ορθογώνιο 128">
            <a:extLst>
              <a:ext uri="{FF2B5EF4-FFF2-40B4-BE49-F238E27FC236}">
                <a16:creationId xmlns:a16="http://schemas.microsoft.com/office/drawing/2014/main" id="{5442FAE5-78B7-8243-D1CC-02C060C703B0}"/>
              </a:ext>
            </a:extLst>
          </p:cNvPr>
          <p:cNvSpPr/>
          <p:nvPr/>
        </p:nvSpPr>
        <p:spPr>
          <a:xfrm>
            <a:off x="948979" y="8391669"/>
            <a:ext cx="5240828" cy="35311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grpSp>
        <p:nvGrpSpPr>
          <p:cNvPr id="198" name="Ομάδα 197">
            <a:extLst>
              <a:ext uri="{FF2B5EF4-FFF2-40B4-BE49-F238E27FC236}">
                <a16:creationId xmlns:a16="http://schemas.microsoft.com/office/drawing/2014/main" id="{2C011C49-2D32-75FA-FF17-95067F935027}"/>
              </a:ext>
            </a:extLst>
          </p:cNvPr>
          <p:cNvGrpSpPr/>
          <p:nvPr/>
        </p:nvGrpSpPr>
        <p:grpSpPr>
          <a:xfrm>
            <a:off x="5662538" y="8262683"/>
            <a:ext cx="7270163" cy="5296629"/>
            <a:chOff x="5662536" y="4412425"/>
            <a:chExt cx="7270163" cy="5296629"/>
          </a:xfrm>
        </p:grpSpPr>
        <p:grpSp>
          <p:nvGrpSpPr>
            <p:cNvPr id="154" name="Ομάδα 153">
              <a:extLst>
                <a:ext uri="{FF2B5EF4-FFF2-40B4-BE49-F238E27FC236}">
                  <a16:creationId xmlns:a16="http://schemas.microsoft.com/office/drawing/2014/main" id="{733355B8-7892-4200-6621-C37E5564C4B0}"/>
                </a:ext>
              </a:extLst>
            </p:cNvPr>
            <p:cNvGrpSpPr/>
            <p:nvPr/>
          </p:nvGrpSpPr>
          <p:grpSpPr>
            <a:xfrm>
              <a:off x="5662536" y="4412425"/>
              <a:ext cx="7270163" cy="3659143"/>
              <a:chOff x="5781642" y="1881706"/>
              <a:chExt cx="7270163" cy="3659143"/>
            </a:xfrm>
          </p:grpSpPr>
          <p:grpSp>
            <p:nvGrpSpPr>
              <p:cNvPr id="149" name="Ομάδα 148">
                <a:extLst>
                  <a:ext uri="{FF2B5EF4-FFF2-40B4-BE49-F238E27FC236}">
                    <a16:creationId xmlns:a16="http://schemas.microsoft.com/office/drawing/2014/main" id="{0BA8303E-DA1E-ADA9-77CB-0A3C9440FE14}"/>
                  </a:ext>
                </a:extLst>
              </p:cNvPr>
              <p:cNvGrpSpPr/>
              <p:nvPr/>
            </p:nvGrpSpPr>
            <p:grpSpPr>
              <a:xfrm>
                <a:off x="7451104" y="1945502"/>
                <a:ext cx="5600701" cy="3545240"/>
                <a:chOff x="9655221" y="5155660"/>
                <a:chExt cx="5868998" cy="3830724"/>
              </a:xfrm>
            </p:grpSpPr>
            <p:pic>
              <p:nvPicPr>
                <p:cNvPr id="152" name="Εικόνα 151">
                  <a:extLst>
                    <a:ext uri="{FF2B5EF4-FFF2-40B4-BE49-F238E27FC236}">
                      <a16:creationId xmlns:a16="http://schemas.microsoft.com/office/drawing/2014/main" id="{30FC48AD-7482-C706-4212-E01FD6A2559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9655221" y="5170901"/>
                  <a:ext cx="5868998" cy="3815483"/>
                </a:xfrm>
                <a:prstGeom prst="rect">
                  <a:avLst/>
                </a:prstGeom>
              </p:spPr>
            </p:pic>
            <p:sp>
              <p:nvSpPr>
                <p:cNvPr id="153" name="Ορθογώνιο 152">
                  <a:extLst>
                    <a:ext uri="{FF2B5EF4-FFF2-40B4-BE49-F238E27FC236}">
                      <a16:creationId xmlns:a16="http://schemas.microsoft.com/office/drawing/2014/main" id="{C00F81F2-3606-D022-AACC-CED77BA7A9B9}"/>
                    </a:ext>
                  </a:extLst>
                </p:cNvPr>
                <p:cNvSpPr/>
                <p:nvPr/>
              </p:nvSpPr>
              <p:spPr>
                <a:xfrm>
                  <a:off x="9660439" y="5155660"/>
                  <a:ext cx="5863780" cy="3830723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l-GR"/>
                </a:p>
              </p:txBody>
            </p:sp>
          </p:grp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1CD18C57-34D3-8D9C-9613-FF387A244BD1}"/>
                  </a:ext>
                </a:extLst>
              </p:cNvPr>
              <p:cNvSpPr txBox="1"/>
              <p:nvPr/>
            </p:nvSpPr>
            <p:spPr>
              <a:xfrm>
                <a:off x="5781642" y="1881706"/>
                <a:ext cx="1664467" cy="36591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spiration</a:t>
                </a:r>
              </a:p>
              <a:p>
                <a:pPr algn="r"/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rate</a:t>
                </a:r>
                <a:endParaRPr lang="pt-PT" sz="12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thylene </a:t>
                </a:r>
              </a:p>
              <a:p>
                <a:pPr algn="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duction 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*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*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*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hroma (C*)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ue angle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A (%)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SC (°Brix)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pt-P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irmness (kg)</a:t>
                </a:r>
              </a:p>
              <a:p>
                <a:pPr algn="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resh </a:t>
                </a:r>
              </a:p>
              <a:p>
                <a:pPr algn="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eight (g)</a:t>
                </a:r>
              </a:p>
              <a:p>
                <a:pPr algn="r">
                  <a:lnSpc>
                    <a:spcPct val="150000"/>
                  </a:lnSpc>
                </a:pP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ryMatter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EE63931F-0651-94DF-DD80-2EDD7BACF2DF}"/>
                </a:ext>
              </a:extLst>
            </p:cNvPr>
            <p:cNvSpPr txBox="1"/>
            <p:nvPr/>
          </p:nvSpPr>
          <p:spPr>
            <a:xfrm rot="16200000">
              <a:off x="9232260" y="6116203"/>
              <a:ext cx="1687594" cy="54981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espiration</a:t>
              </a:r>
            </a:p>
            <a:p>
              <a:pPr algn="r"/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rate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spcBef>
                  <a:spcPts val="600"/>
                </a:spcBef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hylene 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duction 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hroma (C*)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ue angle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A (%)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SC (°Brix)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rmness (kg)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resh 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eight (g)</a:t>
              </a:r>
            </a:p>
            <a:p>
              <a:pPr algn="r">
                <a:lnSpc>
                  <a:spcPct val="200000"/>
                </a:lnSpc>
                <a:spcBef>
                  <a:spcPts val="600"/>
                </a:spcBef>
              </a:pP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ry Matter</a:t>
              </a:r>
            </a:p>
          </p:txBody>
        </p:sp>
      </p:grpSp>
      <p:grpSp>
        <p:nvGrpSpPr>
          <p:cNvPr id="196" name="Ομάδα 195">
            <a:extLst>
              <a:ext uri="{FF2B5EF4-FFF2-40B4-BE49-F238E27FC236}">
                <a16:creationId xmlns:a16="http://schemas.microsoft.com/office/drawing/2014/main" id="{0EA3279B-45E4-2E94-2866-BBB57A766F08}"/>
              </a:ext>
            </a:extLst>
          </p:cNvPr>
          <p:cNvGrpSpPr/>
          <p:nvPr/>
        </p:nvGrpSpPr>
        <p:grpSpPr>
          <a:xfrm>
            <a:off x="12374609" y="8226275"/>
            <a:ext cx="7371935" cy="5399726"/>
            <a:chOff x="12420327" y="4376019"/>
            <a:chExt cx="7371935" cy="5399726"/>
          </a:xfrm>
        </p:grpSpPr>
        <p:grpSp>
          <p:nvGrpSpPr>
            <p:cNvPr id="156" name="Ομάδα 155">
              <a:extLst>
                <a:ext uri="{FF2B5EF4-FFF2-40B4-BE49-F238E27FC236}">
                  <a16:creationId xmlns:a16="http://schemas.microsoft.com/office/drawing/2014/main" id="{885174C8-5E68-B5B8-2C18-B3E1B07A1454}"/>
                </a:ext>
              </a:extLst>
            </p:cNvPr>
            <p:cNvGrpSpPr/>
            <p:nvPr/>
          </p:nvGrpSpPr>
          <p:grpSpPr>
            <a:xfrm>
              <a:off x="12420327" y="4376019"/>
              <a:ext cx="7371935" cy="5399726"/>
              <a:chOff x="-132334" y="5004814"/>
              <a:chExt cx="7371935" cy="5399726"/>
            </a:xfrm>
          </p:grpSpPr>
          <p:grpSp>
            <p:nvGrpSpPr>
              <p:cNvPr id="157" name="Ομάδα 156">
                <a:extLst>
                  <a:ext uri="{FF2B5EF4-FFF2-40B4-BE49-F238E27FC236}">
                    <a16:creationId xmlns:a16="http://schemas.microsoft.com/office/drawing/2014/main" id="{81FC9E3C-B2FD-A95A-1E13-6CA84BBDF14F}"/>
                  </a:ext>
                </a:extLst>
              </p:cNvPr>
              <p:cNvGrpSpPr/>
              <p:nvPr/>
            </p:nvGrpSpPr>
            <p:grpSpPr>
              <a:xfrm>
                <a:off x="-132334" y="5004814"/>
                <a:ext cx="7304588" cy="5399726"/>
                <a:chOff x="7985760" y="5091864"/>
                <a:chExt cx="7304588" cy="5325728"/>
              </a:xfrm>
            </p:grpSpPr>
            <p:sp>
              <p:nvSpPr>
                <p:cNvPr id="160" name="TextBox 159">
                  <a:extLst>
                    <a:ext uri="{FF2B5EF4-FFF2-40B4-BE49-F238E27FC236}">
                      <a16:creationId xmlns:a16="http://schemas.microsoft.com/office/drawing/2014/main" id="{597A2B0E-7523-3265-41E2-4E9CBCEAFD9B}"/>
                    </a:ext>
                  </a:extLst>
                </p:cNvPr>
                <p:cNvSpPr txBox="1"/>
                <p:nvPr/>
              </p:nvSpPr>
              <p:spPr>
                <a:xfrm>
                  <a:off x="7985760" y="5091864"/>
                  <a:ext cx="1664467" cy="365914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piration</a:t>
                  </a:r>
                </a:p>
                <a:p>
                  <a:pPr algn="r"/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rate</a:t>
                  </a:r>
                  <a:endParaRPr lang="pt-PT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thylene 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duction 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*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*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*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oma (C*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ue angle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 (%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 (°Brix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rmness (kg)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resh 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ight (g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en-US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ryMatter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TextBox 160">
                  <a:extLst>
                    <a:ext uri="{FF2B5EF4-FFF2-40B4-BE49-F238E27FC236}">
                      <a16:creationId xmlns:a16="http://schemas.microsoft.com/office/drawing/2014/main" id="{55A70CF4-B39F-0B28-8D6F-DFE1085E786A}"/>
                    </a:ext>
                  </a:extLst>
                </p:cNvPr>
                <p:cNvSpPr txBox="1"/>
                <p:nvPr/>
              </p:nvSpPr>
              <p:spPr>
                <a:xfrm rot="16200000">
                  <a:off x="11709060" y="6836305"/>
                  <a:ext cx="1664467" cy="549810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piration</a:t>
                  </a:r>
                </a:p>
                <a:p>
                  <a:pPr algn="r"/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rate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>
                    <a:spcBef>
                      <a:spcPts val="600"/>
                    </a:spcBef>
                  </a:pP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thylene 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duction 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*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*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*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oma (C*)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ue angle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 (%)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 (°Brix)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rmness (kg)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resh 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ight (g)</a:t>
                  </a:r>
                </a:p>
                <a:p>
                  <a:pPr algn="r">
                    <a:lnSpc>
                      <a:spcPct val="200000"/>
                    </a:lnSpc>
                    <a:spcBef>
                      <a:spcPts val="600"/>
                    </a:spcBef>
                  </a:pPr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ry Matter</a:t>
                  </a:r>
                </a:p>
              </p:txBody>
            </p:sp>
          </p:grpSp>
          <p:sp>
            <p:nvSpPr>
              <p:cNvPr id="158" name="Ορθογώνιο 157">
                <a:extLst>
                  <a:ext uri="{FF2B5EF4-FFF2-40B4-BE49-F238E27FC236}">
                    <a16:creationId xmlns:a16="http://schemas.microsoft.com/office/drawing/2014/main" id="{E0F9FDD5-E922-36EF-3341-38EBBD3C064D}"/>
                  </a:ext>
                </a:extLst>
              </p:cNvPr>
              <p:cNvSpPr/>
              <p:nvPr/>
            </p:nvSpPr>
            <p:spPr>
              <a:xfrm>
                <a:off x="1611086" y="5055652"/>
                <a:ext cx="5628515" cy="3659143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l-GR"/>
              </a:p>
            </p:txBody>
          </p:sp>
        </p:grpSp>
        <p:pic>
          <p:nvPicPr>
            <p:cNvPr id="163" name="Εικόνα 162">
              <a:extLst>
                <a:ext uri="{FF2B5EF4-FFF2-40B4-BE49-F238E27FC236}">
                  <a16:creationId xmlns:a16="http://schemas.microsoft.com/office/drawing/2014/main" id="{A56B5092-3ABC-C01F-E4A1-1914E6F7674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4163747" y="4442097"/>
              <a:ext cx="5628515" cy="3659143"/>
            </a:xfrm>
            <a:prstGeom prst="rect">
              <a:avLst/>
            </a:prstGeom>
          </p:spPr>
        </p:pic>
      </p:grpSp>
      <p:grpSp>
        <p:nvGrpSpPr>
          <p:cNvPr id="180" name="Ομάδα 179">
            <a:extLst>
              <a:ext uri="{FF2B5EF4-FFF2-40B4-BE49-F238E27FC236}">
                <a16:creationId xmlns:a16="http://schemas.microsoft.com/office/drawing/2014/main" id="{6EA3AC93-A664-9341-0768-215332655473}"/>
              </a:ext>
            </a:extLst>
          </p:cNvPr>
          <p:cNvGrpSpPr/>
          <p:nvPr/>
        </p:nvGrpSpPr>
        <p:grpSpPr>
          <a:xfrm>
            <a:off x="5670963" y="4415317"/>
            <a:ext cx="7350561" cy="3659143"/>
            <a:chOff x="6216586" y="1415682"/>
            <a:chExt cx="7313930" cy="3819080"/>
          </a:xfrm>
        </p:grpSpPr>
        <p:pic>
          <p:nvPicPr>
            <p:cNvPr id="181" name="Εικόνα 180">
              <a:extLst>
                <a:ext uri="{FF2B5EF4-FFF2-40B4-BE49-F238E27FC236}">
                  <a16:creationId xmlns:a16="http://schemas.microsoft.com/office/drawing/2014/main" id="{050C48E9-0EBE-CC87-70AD-047F6392E98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865813" y="1438316"/>
              <a:ext cx="5664703" cy="3780655"/>
            </a:xfrm>
            <a:prstGeom prst="rect">
              <a:avLst/>
            </a:prstGeom>
          </p:spPr>
        </p:pic>
        <p:grpSp>
          <p:nvGrpSpPr>
            <p:cNvPr id="182" name="Ομάδα 181">
              <a:extLst>
                <a:ext uri="{FF2B5EF4-FFF2-40B4-BE49-F238E27FC236}">
                  <a16:creationId xmlns:a16="http://schemas.microsoft.com/office/drawing/2014/main" id="{549D62BC-ADF9-EE85-6CD4-495C166FD26E}"/>
                </a:ext>
              </a:extLst>
            </p:cNvPr>
            <p:cNvGrpSpPr/>
            <p:nvPr/>
          </p:nvGrpSpPr>
          <p:grpSpPr>
            <a:xfrm>
              <a:off x="6216586" y="1415682"/>
              <a:ext cx="7274802" cy="3819080"/>
              <a:chOff x="6216586" y="1415682"/>
              <a:chExt cx="7274802" cy="3819080"/>
            </a:xfrm>
          </p:grpSpPr>
          <p:grpSp>
            <p:nvGrpSpPr>
              <p:cNvPr id="183" name="Ομάδα 182">
                <a:extLst>
                  <a:ext uri="{FF2B5EF4-FFF2-40B4-BE49-F238E27FC236}">
                    <a16:creationId xmlns:a16="http://schemas.microsoft.com/office/drawing/2014/main" id="{FEB28557-4458-6569-7A63-3FC6F3F56BA5}"/>
                  </a:ext>
                </a:extLst>
              </p:cNvPr>
              <p:cNvGrpSpPr/>
              <p:nvPr/>
            </p:nvGrpSpPr>
            <p:grpSpPr>
              <a:xfrm>
                <a:off x="6216586" y="1415682"/>
                <a:ext cx="7270164" cy="3819080"/>
                <a:chOff x="7985760" y="5044146"/>
                <a:chExt cx="7270164" cy="3819080"/>
              </a:xfrm>
            </p:grpSpPr>
            <p:sp>
              <p:nvSpPr>
                <p:cNvPr id="185" name="Ορθογώνιο 184">
                  <a:extLst>
                    <a:ext uri="{FF2B5EF4-FFF2-40B4-BE49-F238E27FC236}">
                      <a16:creationId xmlns:a16="http://schemas.microsoft.com/office/drawing/2014/main" id="{D5BDCBB7-C19B-9EF2-EF05-85C9196BE155}"/>
                    </a:ext>
                  </a:extLst>
                </p:cNvPr>
                <p:cNvSpPr/>
                <p:nvPr/>
              </p:nvSpPr>
              <p:spPr>
                <a:xfrm>
                  <a:off x="9616807" y="5073706"/>
                  <a:ext cx="5639117" cy="3780654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6"/>
                </a:lnRef>
                <a:fillRef idx="1">
                  <a:schemeClr val="lt1"/>
                </a:fillRef>
                <a:effectRef idx="0">
                  <a:schemeClr val="accent6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l-GR"/>
                </a:p>
              </p:txBody>
            </p:sp>
            <p:sp>
              <p:nvSpPr>
                <p:cNvPr id="186" name="TextBox 185">
                  <a:extLst>
                    <a:ext uri="{FF2B5EF4-FFF2-40B4-BE49-F238E27FC236}">
                      <a16:creationId xmlns:a16="http://schemas.microsoft.com/office/drawing/2014/main" id="{CEA399F7-D7B0-F3B8-1E65-E938A5919781}"/>
                    </a:ext>
                  </a:extLst>
                </p:cNvPr>
                <p:cNvSpPr txBox="1"/>
                <p:nvPr/>
              </p:nvSpPr>
              <p:spPr>
                <a:xfrm>
                  <a:off x="7985760" y="5044146"/>
                  <a:ext cx="1664467" cy="38190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spiration</a:t>
                  </a:r>
                </a:p>
                <a:p>
                  <a:pPr algn="r"/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rate</a:t>
                  </a:r>
                  <a:endParaRPr lang="pt-PT" sz="12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thylene 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duction 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*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*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*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roma (C*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ue angle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A (%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 (°Brix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pt-PT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irmness (kg)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resh </a:t>
                  </a:r>
                </a:p>
                <a:p>
                  <a:pPr algn="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ight (g)</a:t>
                  </a:r>
                </a:p>
                <a:p>
                  <a:pPr algn="r">
                    <a:lnSpc>
                      <a:spcPct val="150000"/>
                    </a:lnSpc>
                  </a:pPr>
                  <a:r>
                    <a:rPr lang="en-US" sz="12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ryMatter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84" name="Ορθογώνιο 183">
                <a:extLst>
                  <a:ext uri="{FF2B5EF4-FFF2-40B4-BE49-F238E27FC236}">
                    <a16:creationId xmlns:a16="http://schemas.microsoft.com/office/drawing/2014/main" id="{56BD01F8-00C8-ADAA-0807-C5D707E21C7E}"/>
                  </a:ext>
                </a:extLst>
              </p:cNvPr>
              <p:cNvSpPr/>
              <p:nvPr/>
            </p:nvSpPr>
            <p:spPr>
              <a:xfrm>
                <a:off x="7862873" y="1445241"/>
                <a:ext cx="5628515" cy="376535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l-GR"/>
              </a:p>
            </p:txBody>
          </p:sp>
        </p:grpSp>
      </p:grpSp>
      <p:grpSp>
        <p:nvGrpSpPr>
          <p:cNvPr id="197" name="Ομάδα 196">
            <a:extLst>
              <a:ext uri="{FF2B5EF4-FFF2-40B4-BE49-F238E27FC236}">
                <a16:creationId xmlns:a16="http://schemas.microsoft.com/office/drawing/2014/main" id="{D43B5573-7580-5E83-E34D-B0F2BAB3122E}"/>
              </a:ext>
            </a:extLst>
          </p:cNvPr>
          <p:cNvGrpSpPr/>
          <p:nvPr/>
        </p:nvGrpSpPr>
        <p:grpSpPr>
          <a:xfrm>
            <a:off x="12486172" y="4407878"/>
            <a:ext cx="7200496" cy="3659143"/>
            <a:chOff x="12547132" y="527140"/>
            <a:chExt cx="7200496" cy="3659143"/>
          </a:xfrm>
        </p:grpSpPr>
        <p:grpSp>
          <p:nvGrpSpPr>
            <p:cNvPr id="192" name="Ομάδα 191">
              <a:extLst>
                <a:ext uri="{FF2B5EF4-FFF2-40B4-BE49-F238E27FC236}">
                  <a16:creationId xmlns:a16="http://schemas.microsoft.com/office/drawing/2014/main" id="{6A352CD5-DA7C-5CCE-76ED-5C2ABDCE6F5E}"/>
                </a:ext>
              </a:extLst>
            </p:cNvPr>
            <p:cNvGrpSpPr/>
            <p:nvPr/>
          </p:nvGrpSpPr>
          <p:grpSpPr>
            <a:xfrm>
              <a:off x="14226807" y="618580"/>
              <a:ext cx="5520821" cy="3567703"/>
              <a:chOff x="14266689" y="1127070"/>
              <a:chExt cx="5643764" cy="3766473"/>
            </a:xfrm>
          </p:grpSpPr>
          <p:pic>
            <p:nvPicPr>
              <p:cNvPr id="193" name="Εικόνα 192">
                <a:extLst>
                  <a:ext uri="{FF2B5EF4-FFF2-40B4-BE49-F238E27FC236}">
                    <a16:creationId xmlns:a16="http://schemas.microsoft.com/office/drawing/2014/main" id="{469F058B-2C29-C3DC-CC2B-2F3513016EC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4271335" y="1129963"/>
                <a:ext cx="5639118" cy="3763580"/>
              </a:xfrm>
              <a:prstGeom prst="rect">
                <a:avLst/>
              </a:prstGeom>
            </p:spPr>
          </p:pic>
          <p:sp>
            <p:nvSpPr>
              <p:cNvPr id="194" name="Ορθογώνιο 193">
                <a:extLst>
                  <a:ext uri="{FF2B5EF4-FFF2-40B4-BE49-F238E27FC236}">
                    <a16:creationId xmlns:a16="http://schemas.microsoft.com/office/drawing/2014/main" id="{53765332-2530-EAD5-AF50-F697DE1D8D83}"/>
                  </a:ext>
                </a:extLst>
              </p:cNvPr>
              <p:cNvSpPr/>
              <p:nvPr/>
            </p:nvSpPr>
            <p:spPr>
              <a:xfrm>
                <a:off x="14266689" y="1127070"/>
                <a:ext cx="5628515" cy="376535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l-GR"/>
              </a:p>
            </p:txBody>
          </p:sp>
        </p:grp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36E51BDF-5232-6D5B-8B3B-C0ED1E819CE0}"/>
                </a:ext>
              </a:extLst>
            </p:cNvPr>
            <p:cNvSpPr txBox="1"/>
            <p:nvPr/>
          </p:nvSpPr>
          <p:spPr>
            <a:xfrm>
              <a:off x="12547132" y="527140"/>
              <a:ext cx="1664467" cy="36591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espiration</a:t>
              </a:r>
            </a:p>
            <a:p>
              <a:pPr algn="r"/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rate</a:t>
              </a:r>
              <a:endParaRPr lang="pt-PT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thylene 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duction 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L*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*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*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hroma (C*)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ue angle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A (%)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SC (°Brix)</a:t>
              </a:r>
            </a:p>
            <a:p>
              <a:pPr algn="r">
                <a:lnSpc>
                  <a:spcPct val="150000"/>
                </a:lnSpc>
              </a:pPr>
              <a:r>
                <a:rPr lang="pt-P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rmness (kg)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resh </a:t>
              </a:r>
            </a:p>
            <a:p>
              <a:pPr algn="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eight (g)</a:t>
              </a:r>
            </a:p>
            <a:p>
              <a:pPr algn="r">
                <a:lnSpc>
                  <a:spcPct val="150000"/>
                </a:lnSpc>
              </a:pPr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ryMatter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15E692E1-ED7F-8D45-62C0-388997F9326E}"/>
              </a:ext>
            </a:extLst>
          </p:cNvPr>
          <p:cNvSpPr txBox="1"/>
          <p:nvPr/>
        </p:nvSpPr>
        <p:spPr>
          <a:xfrm>
            <a:off x="89409" y="74562"/>
            <a:ext cx="19709891" cy="15267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89"/>
              </a:spcAft>
            </a:pPr>
            <a:r>
              <a:rPr lang="en-US" sz="2667" b="1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Plants</a:t>
            </a:r>
          </a:p>
          <a:p>
            <a:pPr algn="just">
              <a:lnSpc>
                <a:spcPct val="115000"/>
              </a:lnSpc>
              <a:spcAft>
                <a:spcPts val="889"/>
              </a:spcAft>
            </a:pPr>
            <a:r>
              <a:rPr lang="en-US" sz="2667" b="1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Canopy design drives photosynthetic performance, light environment, and fruit quality in peach (</a:t>
            </a:r>
            <a:r>
              <a:rPr lang="en-US" sz="2667" b="1" i="1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Prunus persica</a:t>
            </a:r>
            <a:r>
              <a:rPr lang="en-US" sz="2667" b="1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 L. Batsch)</a:t>
            </a:r>
            <a:endParaRPr lang="el-GR" sz="1778" dirty="0"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889"/>
              </a:spcAft>
            </a:pPr>
            <a:endParaRPr lang="en-US" sz="1556" dirty="0"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946A13B-5059-F54D-57D9-C976BC1B5B74}"/>
              </a:ext>
            </a:extLst>
          </p:cNvPr>
          <p:cNvSpPr txBox="1"/>
          <p:nvPr/>
        </p:nvSpPr>
        <p:spPr>
          <a:xfrm>
            <a:off x="89409" y="1521728"/>
            <a:ext cx="19709891" cy="16626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89"/>
              </a:spcAft>
            </a:pPr>
            <a:r>
              <a:rPr lang="en-US" sz="2667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Ioannis Chatzieffraimidis, Dimos Stouris, Marina-Rafailia Kyrou, Fokion Papathanasiou, Evangelos Karagiannis*</a:t>
            </a:r>
            <a:endParaRPr lang="el-GR" sz="2074" dirty="0"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889"/>
              </a:spcAft>
            </a:pPr>
            <a:r>
              <a:rPr lang="en-US" sz="2667" i="1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Department of Agriculture, School of Agricultural Sciences, University of Western Macedonia, 53100 Florina, Greece</a:t>
            </a:r>
            <a:endParaRPr lang="el-GR" sz="2074" dirty="0"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r">
              <a:lnSpc>
                <a:spcPct val="115000"/>
              </a:lnSpc>
              <a:spcAft>
                <a:spcPts val="889"/>
              </a:spcAft>
            </a:pPr>
            <a:r>
              <a:rPr lang="en-US" sz="2370" dirty="0">
                <a:latin typeface="Palatino Linotype" panose="02040502050505030304" pitchFamily="18" charset="0"/>
                <a:ea typeface="inter"/>
                <a:cs typeface="Times New Roman" panose="02020603050405020304" pitchFamily="18" charset="0"/>
              </a:rPr>
              <a:t>*Corresponding Author: ekaragiannis@uowm.gr</a:t>
            </a:r>
            <a:r>
              <a:rPr lang="en-US" sz="1556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  <a:endParaRPr lang="el-GR" sz="2667" dirty="0">
              <a:latin typeface="Palatino Linotype" panose="0204050205050503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9D3AF1A-52E9-49FC-9DE9-BEAA08A17465}"/>
              </a:ext>
            </a:extLst>
          </p:cNvPr>
          <p:cNvSpPr txBox="1"/>
          <p:nvPr/>
        </p:nvSpPr>
        <p:spPr>
          <a:xfrm>
            <a:off x="1" y="13277265"/>
            <a:ext cx="19720254" cy="23666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  <a:buNone/>
            </a:pPr>
            <a:r>
              <a:rPr lang="en-US" sz="2600" b="1" dirty="0"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2600" b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: 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earson correlation matrices between (a) physiological parameters and (b) fruit quality traits in </a:t>
            </a:r>
            <a:r>
              <a:rPr lang="en-US" sz="26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runus persica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2600" dirty="0" err="1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vs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 ‘</a:t>
            </a:r>
            <a:r>
              <a:rPr lang="en-US" sz="2600" dirty="0" err="1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latibelle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’ and ‘Mirel’ under different fruit loads (20 and 50 leaves per fruit). Data represent the mean values of the 2023 and 2024 seasons. The matrices display Pearson correlation coefficients (</a:t>
            </a:r>
            <a:r>
              <a:rPr lang="en-US" sz="26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r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between pairs of variables, with color shading indicating the strength and direction of the relationship (warm tones = positive correlations; cool tones = negative correlations). Significance levels are indicated as </a:t>
            </a:r>
            <a:r>
              <a:rPr lang="en-US" sz="26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&lt; 0.05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*), </a:t>
            </a:r>
            <a:r>
              <a:rPr lang="en-US" sz="26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&lt; 0.01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**), and </a:t>
            </a:r>
            <a:r>
              <a:rPr lang="en-US" sz="2600" i="1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 &lt; 0.001</a:t>
            </a:r>
            <a:r>
              <a:rPr lang="en-US" sz="2600" dirty="0">
                <a:effectLst/>
                <a:latin typeface="Palatino Linotype" panose="0204050205050503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***).</a:t>
            </a:r>
            <a:endParaRPr lang="el-GR" sz="2600" dirty="0">
              <a:effectLst/>
              <a:latin typeface="Palatino Linotype" panose="0204050205050503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2971463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Θέμα του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Θέμα του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Θέμα του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63</TotalTime>
  <Words>442</Words>
  <Application>Microsoft Office PowerPoint</Application>
  <PresentationFormat>Προσαρμογή</PresentationFormat>
  <Paragraphs>146</Paragraphs>
  <Slides>1</Slides>
  <Notes>0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Θέμα του Office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OANNIS CHATZIEFFRAIMIDIS</dc:creator>
  <cp:lastModifiedBy>IOANNIS CHATZIEFFRAIMIDIS</cp:lastModifiedBy>
  <cp:revision>4</cp:revision>
  <dcterms:created xsi:type="dcterms:W3CDTF">2025-11-05T20:47:40Z</dcterms:created>
  <dcterms:modified xsi:type="dcterms:W3CDTF">2025-11-20T09:48:31Z</dcterms:modified>
</cp:coreProperties>
</file>